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2" r:id="rId1"/>
  </p:sldMasterIdLst>
  <p:sldIdLst>
    <p:sldId id="256" r:id="rId2"/>
  </p:sldIdLst>
  <p:sldSz cx="8686800" cy="16303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F2F2"/>
    <a:srgbClr val="88AACD"/>
    <a:srgbClr val="A7CDF4"/>
    <a:srgbClr val="62A8A4"/>
    <a:srgbClr val="59A09C"/>
    <a:srgbClr val="6476D0"/>
    <a:srgbClr val="8FAFD2"/>
    <a:srgbClr val="FEDAA5"/>
    <a:srgbClr val="E58C45"/>
    <a:srgbClr val="FE9D4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850"/>
    <p:restoredTop sz="94658"/>
  </p:normalViewPr>
  <p:slideViewPr>
    <p:cSldViewPr snapToGrid="0">
      <p:cViewPr varScale="1">
        <p:scale>
          <a:sx n="50" d="100"/>
          <a:sy n="50" d="100"/>
        </p:scale>
        <p:origin x="425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51510" y="2668210"/>
            <a:ext cx="7383780" cy="5676077"/>
          </a:xfrm>
        </p:spPr>
        <p:txBody>
          <a:bodyPr anchor="b"/>
          <a:lstStyle>
            <a:lvl1pPr algn="ctr">
              <a:defRPr sz="57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5850" y="8563178"/>
            <a:ext cx="6515100" cy="3936268"/>
          </a:xfrm>
        </p:spPr>
        <p:txBody>
          <a:bodyPr/>
          <a:lstStyle>
            <a:lvl1pPr marL="0" indent="0" algn="ctr">
              <a:buNone/>
              <a:defRPr sz="2280"/>
            </a:lvl1pPr>
            <a:lvl2pPr marL="434340" indent="0" algn="ctr">
              <a:buNone/>
              <a:defRPr sz="1900"/>
            </a:lvl2pPr>
            <a:lvl3pPr marL="868680" indent="0" algn="ctr">
              <a:buNone/>
              <a:defRPr sz="1710"/>
            </a:lvl3pPr>
            <a:lvl4pPr marL="1303020" indent="0" algn="ctr">
              <a:buNone/>
              <a:defRPr sz="1520"/>
            </a:lvl4pPr>
            <a:lvl5pPr marL="1737360" indent="0" algn="ctr">
              <a:buNone/>
              <a:defRPr sz="1520"/>
            </a:lvl5pPr>
            <a:lvl6pPr marL="2171700" indent="0" algn="ctr">
              <a:buNone/>
              <a:defRPr sz="1520"/>
            </a:lvl6pPr>
            <a:lvl7pPr marL="2606040" indent="0" algn="ctr">
              <a:buNone/>
              <a:defRPr sz="1520"/>
            </a:lvl7pPr>
            <a:lvl8pPr marL="3040380" indent="0" algn="ctr">
              <a:buNone/>
              <a:defRPr sz="1520"/>
            </a:lvl8pPr>
            <a:lvl9pPr marL="3474720" indent="0" algn="ctr">
              <a:buNone/>
              <a:defRPr sz="15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4DC71-C65C-4C47-AB97-8915C5D58C3D}" type="datetimeFigureOut">
              <a:rPr lang="en-US" smtClean="0"/>
              <a:t>1/3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E723-9050-3B41-90C1-A16B0FFDAD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311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4DC71-C65C-4C47-AB97-8915C5D58C3D}" type="datetimeFigureOut">
              <a:rPr lang="en-US" smtClean="0"/>
              <a:t>1/3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E723-9050-3B41-90C1-A16B0FFDAD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559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216492" y="868017"/>
            <a:ext cx="1873091" cy="138165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7218" y="868017"/>
            <a:ext cx="5510689" cy="138165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4DC71-C65C-4C47-AB97-8915C5D58C3D}" type="datetimeFigureOut">
              <a:rPr lang="en-US" smtClean="0"/>
              <a:t>1/3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E723-9050-3B41-90C1-A16B0FFDAD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715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4DC71-C65C-4C47-AB97-8915C5D58C3D}" type="datetimeFigureOut">
              <a:rPr lang="en-US" smtClean="0"/>
              <a:t>1/3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E723-9050-3B41-90C1-A16B0FFDAD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6748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2694" y="4064589"/>
            <a:ext cx="7492365" cy="6781854"/>
          </a:xfrm>
        </p:spPr>
        <p:txBody>
          <a:bodyPr anchor="b"/>
          <a:lstStyle>
            <a:lvl1pPr>
              <a:defRPr sz="57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2694" y="10910602"/>
            <a:ext cx="7492365" cy="3566417"/>
          </a:xfrm>
        </p:spPr>
        <p:txBody>
          <a:bodyPr/>
          <a:lstStyle>
            <a:lvl1pPr marL="0" indent="0">
              <a:buNone/>
              <a:defRPr sz="2280">
                <a:solidFill>
                  <a:schemeClr val="tx1">
                    <a:tint val="82000"/>
                  </a:schemeClr>
                </a:solidFill>
              </a:defRPr>
            </a:lvl1pPr>
            <a:lvl2pPr marL="434340" indent="0">
              <a:buNone/>
              <a:defRPr sz="1900">
                <a:solidFill>
                  <a:schemeClr val="tx1">
                    <a:tint val="82000"/>
                  </a:schemeClr>
                </a:solidFill>
              </a:defRPr>
            </a:lvl2pPr>
            <a:lvl3pPr marL="868680" indent="0">
              <a:buNone/>
              <a:defRPr sz="1710">
                <a:solidFill>
                  <a:schemeClr val="tx1">
                    <a:tint val="82000"/>
                  </a:schemeClr>
                </a:solidFill>
              </a:defRPr>
            </a:lvl3pPr>
            <a:lvl4pPr marL="1303020" indent="0">
              <a:buNone/>
              <a:defRPr sz="1520">
                <a:solidFill>
                  <a:schemeClr val="tx1">
                    <a:tint val="82000"/>
                  </a:schemeClr>
                </a:solidFill>
              </a:defRPr>
            </a:lvl4pPr>
            <a:lvl5pPr marL="1737360" indent="0">
              <a:buNone/>
              <a:defRPr sz="1520">
                <a:solidFill>
                  <a:schemeClr val="tx1">
                    <a:tint val="82000"/>
                  </a:schemeClr>
                </a:solidFill>
              </a:defRPr>
            </a:lvl5pPr>
            <a:lvl6pPr marL="2171700" indent="0">
              <a:buNone/>
              <a:defRPr sz="1520">
                <a:solidFill>
                  <a:schemeClr val="tx1">
                    <a:tint val="82000"/>
                  </a:schemeClr>
                </a:solidFill>
              </a:defRPr>
            </a:lvl6pPr>
            <a:lvl7pPr marL="2606040" indent="0">
              <a:buNone/>
              <a:defRPr sz="1520">
                <a:solidFill>
                  <a:schemeClr val="tx1">
                    <a:tint val="82000"/>
                  </a:schemeClr>
                </a:solidFill>
              </a:defRPr>
            </a:lvl7pPr>
            <a:lvl8pPr marL="3040380" indent="0">
              <a:buNone/>
              <a:defRPr sz="1520">
                <a:solidFill>
                  <a:schemeClr val="tx1">
                    <a:tint val="82000"/>
                  </a:schemeClr>
                </a:solidFill>
              </a:defRPr>
            </a:lvl8pPr>
            <a:lvl9pPr marL="3474720" indent="0">
              <a:buNone/>
              <a:defRPr sz="152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4DC71-C65C-4C47-AB97-8915C5D58C3D}" type="datetimeFigureOut">
              <a:rPr lang="en-US" smtClean="0"/>
              <a:t>1/3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E723-9050-3B41-90C1-A16B0FFDAD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2800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7218" y="4340086"/>
            <a:ext cx="3691890" cy="103445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97693" y="4340086"/>
            <a:ext cx="3691890" cy="103445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4DC71-C65C-4C47-AB97-8915C5D58C3D}" type="datetimeFigureOut">
              <a:rPr lang="en-US" smtClean="0"/>
              <a:t>1/3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E723-9050-3B41-90C1-A16B0FFDAD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6555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8349" y="868020"/>
            <a:ext cx="7492365" cy="315128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8350" y="3996654"/>
            <a:ext cx="3674923" cy="1958698"/>
          </a:xfrm>
        </p:spPr>
        <p:txBody>
          <a:bodyPr anchor="b"/>
          <a:lstStyle>
            <a:lvl1pPr marL="0" indent="0">
              <a:buNone/>
              <a:defRPr sz="2280" b="1"/>
            </a:lvl1pPr>
            <a:lvl2pPr marL="434340" indent="0">
              <a:buNone/>
              <a:defRPr sz="1900" b="1"/>
            </a:lvl2pPr>
            <a:lvl3pPr marL="868680" indent="0">
              <a:buNone/>
              <a:defRPr sz="1710" b="1"/>
            </a:lvl3pPr>
            <a:lvl4pPr marL="1303020" indent="0">
              <a:buNone/>
              <a:defRPr sz="1520" b="1"/>
            </a:lvl4pPr>
            <a:lvl5pPr marL="1737360" indent="0">
              <a:buNone/>
              <a:defRPr sz="1520" b="1"/>
            </a:lvl5pPr>
            <a:lvl6pPr marL="2171700" indent="0">
              <a:buNone/>
              <a:defRPr sz="1520" b="1"/>
            </a:lvl6pPr>
            <a:lvl7pPr marL="2606040" indent="0">
              <a:buNone/>
              <a:defRPr sz="1520" b="1"/>
            </a:lvl7pPr>
            <a:lvl8pPr marL="3040380" indent="0">
              <a:buNone/>
              <a:defRPr sz="1520" b="1"/>
            </a:lvl8pPr>
            <a:lvl9pPr marL="3474720" indent="0">
              <a:buNone/>
              <a:defRPr sz="15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8350" y="5955352"/>
            <a:ext cx="3674923" cy="875942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97693" y="3996654"/>
            <a:ext cx="3693021" cy="1958698"/>
          </a:xfrm>
        </p:spPr>
        <p:txBody>
          <a:bodyPr anchor="b"/>
          <a:lstStyle>
            <a:lvl1pPr marL="0" indent="0">
              <a:buNone/>
              <a:defRPr sz="2280" b="1"/>
            </a:lvl1pPr>
            <a:lvl2pPr marL="434340" indent="0">
              <a:buNone/>
              <a:defRPr sz="1900" b="1"/>
            </a:lvl2pPr>
            <a:lvl3pPr marL="868680" indent="0">
              <a:buNone/>
              <a:defRPr sz="1710" b="1"/>
            </a:lvl3pPr>
            <a:lvl4pPr marL="1303020" indent="0">
              <a:buNone/>
              <a:defRPr sz="1520" b="1"/>
            </a:lvl4pPr>
            <a:lvl5pPr marL="1737360" indent="0">
              <a:buNone/>
              <a:defRPr sz="1520" b="1"/>
            </a:lvl5pPr>
            <a:lvl6pPr marL="2171700" indent="0">
              <a:buNone/>
              <a:defRPr sz="1520" b="1"/>
            </a:lvl6pPr>
            <a:lvl7pPr marL="2606040" indent="0">
              <a:buNone/>
              <a:defRPr sz="1520" b="1"/>
            </a:lvl7pPr>
            <a:lvl8pPr marL="3040380" indent="0">
              <a:buNone/>
              <a:defRPr sz="1520" b="1"/>
            </a:lvl8pPr>
            <a:lvl9pPr marL="3474720" indent="0">
              <a:buNone/>
              <a:defRPr sz="15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97693" y="5955352"/>
            <a:ext cx="3693021" cy="875942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4DC71-C65C-4C47-AB97-8915C5D58C3D}" type="datetimeFigureOut">
              <a:rPr lang="en-US" smtClean="0"/>
              <a:t>1/3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E723-9050-3B41-90C1-A16B0FFDAD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683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4DC71-C65C-4C47-AB97-8915C5D58C3D}" type="datetimeFigureOut">
              <a:rPr lang="en-US" smtClean="0"/>
              <a:t>1/3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E723-9050-3B41-90C1-A16B0FFDAD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552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4DC71-C65C-4C47-AB97-8915C5D58C3D}" type="datetimeFigureOut">
              <a:rPr lang="en-US" smtClean="0"/>
              <a:t>1/3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E723-9050-3B41-90C1-A16B0FFDAD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38397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8349" y="1086908"/>
            <a:ext cx="2801719" cy="3804179"/>
          </a:xfrm>
        </p:spPr>
        <p:txBody>
          <a:bodyPr anchor="b"/>
          <a:lstStyle>
            <a:lvl1pPr>
              <a:defRPr sz="30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93021" y="2347424"/>
            <a:ext cx="4397693" cy="11586141"/>
          </a:xfrm>
        </p:spPr>
        <p:txBody>
          <a:bodyPr/>
          <a:lstStyle>
            <a:lvl1pPr>
              <a:defRPr sz="3040"/>
            </a:lvl1pPr>
            <a:lvl2pPr>
              <a:defRPr sz="2660"/>
            </a:lvl2pPr>
            <a:lvl3pPr>
              <a:defRPr sz="228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8349" y="4891087"/>
            <a:ext cx="2801719" cy="9061345"/>
          </a:xfrm>
        </p:spPr>
        <p:txBody>
          <a:bodyPr/>
          <a:lstStyle>
            <a:lvl1pPr marL="0" indent="0">
              <a:buNone/>
              <a:defRPr sz="1520"/>
            </a:lvl1pPr>
            <a:lvl2pPr marL="434340" indent="0">
              <a:buNone/>
              <a:defRPr sz="1330"/>
            </a:lvl2pPr>
            <a:lvl3pPr marL="868680" indent="0">
              <a:buNone/>
              <a:defRPr sz="1140"/>
            </a:lvl3pPr>
            <a:lvl4pPr marL="1303020" indent="0">
              <a:buNone/>
              <a:defRPr sz="950"/>
            </a:lvl4pPr>
            <a:lvl5pPr marL="1737360" indent="0">
              <a:buNone/>
              <a:defRPr sz="950"/>
            </a:lvl5pPr>
            <a:lvl6pPr marL="2171700" indent="0">
              <a:buNone/>
              <a:defRPr sz="950"/>
            </a:lvl6pPr>
            <a:lvl7pPr marL="2606040" indent="0">
              <a:buNone/>
              <a:defRPr sz="950"/>
            </a:lvl7pPr>
            <a:lvl8pPr marL="3040380" indent="0">
              <a:buNone/>
              <a:defRPr sz="950"/>
            </a:lvl8pPr>
            <a:lvl9pPr marL="3474720" indent="0">
              <a:buNone/>
              <a:defRPr sz="9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4DC71-C65C-4C47-AB97-8915C5D58C3D}" type="datetimeFigureOut">
              <a:rPr lang="en-US" smtClean="0"/>
              <a:t>1/3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E723-9050-3B41-90C1-A16B0FFDAD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9046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8349" y="1086908"/>
            <a:ext cx="2801719" cy="3804179"/>
          </a:xfrm>
        </p:spPr>
        <p:txBody>
          <a:bodyPr anchor="b"/>
          <a:lstStyle>
            <a:lvl1pPr>
              <a:defRPr sz="30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93021" y="2347424"/>
            <a:ext cx="4397693" cy="11586141"/>
          </a:xfrm>
        </p:spPr>
        <p:txBody>
          <a:bodyPr anchor="t"/>
          <a:lstStyle>
            <a:lvl1pPr marL="0" indent="0">
              <a:buNone/>
              <a:defRPr sz="3040"/>
            </a:lvl1pPr>
            <a:lvl2pPr marL="434340" indent="0">
              <a:buNone/>
              <a:defRPr sz="2660"/>
            </a:lvl2pPr>
            <a:lvl3pPr marL="868680" indent="0">
              <a:buNone/>
              <a:defRPr sz="2280"/>
            </a:lvl3pPr>
            <a:lvl4pPr marL="1303020" indent="0">
              <a:buNone/>
              <a:defRPr sz="1900"/>
            </a:lvl4pPr>
            <a:lvl5pPr marL="1737360" indent="0">
              <a:buNone/>
              <a:defRPr sz="1900"/>
            </a:lvl5pPr>
            <a:lvl6pPr marL="2171700" indent="0">
              <a:buNone/>
              <a:defRPr sz="1900"/>
            </a:lvl6pPr>
            <a:lvl7pPr marL="2606040" indent="0">
              <a:buNone/>
              <a:defRPr sz="1900"/>
            </a:lvl7pPr>
            <a:lvl8pPr marL="3040380" indent="0">
              <a:buNone/>
              <a:defRPr sz="1900"/>
            </a:lvl8pPr>
            <a:lvl9pPr marL="3474720" indent="0">
              <a:buNone/>
              <a:defRPr sz="19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8349" y="4891087"/>
            <a:ext cx="2801719" cy="9061345"/>
          </a:xfrm>
        </p:spPr>
        <p:txBody>
          <a:bodyPr/>
          <a:lstStyle>
            <a:lvl1pPr marL="0" indent="0">
              <a:buNone/>
              <a:defRPr sz="1520"/>
            </a:lvl1pPr>
            <a:lvl2pPr marL="434340" indent="0">
              <a:buNone/>
              <a:defRPr sz="1330"/>
            </a:lvl2pPr>
            <a:lvl3pPr marL="868680" indent="0">
              <a:buNone/>
              <a:defRPr sz="1140"/>
            </a:lvl3pPr>
            <a:lvl4pPr marL="1303020" indent="0">
              <a:buNone/>
              <a:defRPr sz="950"/>
            </a:lvl4pPr>
            <a:lvl5pPr marL="1737360" indent="0">
              <a:buNone/>
              <a:defRPr sz="950"/>
            </a:lvl5pPr>
            <a:lvl6pPr marL="2171700" indent="0">
              <a:buNone/>
              <a:defRPr sz="950"/>
            </a:lvl6pPr>
            <a:lvl7pPr marL="2606040" indent="0">
              <a:buNone/>
              <a:defRPr sz="950"/>
            </a:lvl7pPr>
            <a:lvl8pPr marL="3040380" indent="0">
              <a:buNone/>
              <a:defRPr sz="950"/>
            </a:lvl8pPr>
            <a:lvl9pPr marL="3474720" indent="0">
              <a:buNone/>
              <a:defRPr sz="9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4DC71-C65C-4C47-AB97-8915C5D58C3D}" type="datetimeFigureOut">
              <a:rPr lang="en-US" smtClean="0"/>
              <a:t>1/3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E723-9050-3B41-90C1-A16B0FFDAD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68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7218" y="868020"/>
            <a:ext cx="7492365" cy="31512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7218" y="4340086"/>
            <a:ext cx="7492365" cy="103445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7218" y="15111049"/>
            <a:ext cx="1954530" cy="8680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4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04DC71-C65C-4C47-AB97-8915C5D58C3D}" type="datetimeFigureOut">
              <a:rPr lang="en-US" smtClean="0"/>
              <a:t>1/3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77503" y="15111049"/>
            <a:ext cx="2931795" cy="8680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4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135053" y="15111049"/>
            <a:ext cx="1954530" cy="8680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4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54DE723-9050-3B41-90C1-A16B0FFDAD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92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868680" rtl="0" eaLnBrk="1" latinLnBrk="0" hangingPunct="1">
        <a:lnSpc>
          <a:spcPct val="90000"/>
        </a:lnSpc>
        <a:spcBef>
          <a:spcPct val="0"/>
        </a:spcBef>
        <a:buNone/>
        <a:defRPr sz="41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7170" indent="-217170" algn="l" defTabSz="868680" rtl="0" eaLnBrk="1" latinLnBrk="0" hangingPunct="1">
        <a:lnSpc>
          <a:spcPct val="90000"/>
        </a:lnSpc>
        <a:spcBef>
          <a:spcPts val="950"/>
        </a:spcBef>
        <a:buFont typeface="Arial" panose="020B0604020202020204" pitchFamily="34" charset="0"/>
        <a:buChar char="•"/>
        <a:defRPr sz="2660" kern="1200">
          <a:solidFill>
            <a:schemeClr val="tx1"/>
          </a:solidFill>
          <a:latin typeface="+mn-lt"/>
          <a:ea typeface="+mn-ea"/>
          <a:cs typeface="+mn-cs"/>
        </a:defRPr>
      </a:lvl1pPr>
      <a:lvl2pPr marL="651510" indent="-217170" algn="l" defTabSz="868680" rtl="0" eaLnBrk="1" latinLnBrk="0" hangingPunct="1">
        <a:lnSpc>
          <a:spcPct val="90000"/>
        </a:lnSpc>
        <a:spcBef>
          <a:spcPts val="475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2pPr>
      <a:lvl3pPr marL="1085850" indent="-217170" algn="l" defTabSz="868680" rtl="0" eaLnBrk="1" latinLnBrk="0" hangingPunct="1">
        <a:lnSpc>
          <a:spcPct val="90000"/>
        </a:lnSpc>
        <a:spcBef>
          <a:spcPts val="475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520190" indent="-217170" algn="l" defTabSz="868680" rtl="0" eaLnBrk="1" latinLnBrk="0" hangingPunct="1">
        <a:lnSpc>
          <a:spcPct val="90000"/>
        </a:lnSpc>
        <a:spcBef>
          <a:spcPts val="475"/>
        </a:spcBef>
        <a:buFont typeface="Arial" panose="020B0604020202020204" pitchFamily="34" charset="0"/>
        <a:buChar char="•"/>
        <a:defRPr sz="1710" kern="1200">
          <a:solidFill>
            <a:schemeClr val="tx1"/>
          </a:solidFill>
          <a:latin typeface="+mn-lt"/>
          <a:ea typeface="+mn-ea"/>
          <a:cs typeface="+mn-cs"/>
        </a:defRPr>
      </a:lvl4pPr>
      <a:lvl5pPr marL="1954530" indent="-217170" algn="l" defTabSz="868680" rtl="0" eaLnBrk="1" latinLnBrk="0" hangingPunct="1">
        <a:lnSpc>
          <a:spcPct val="90000"/>
        </a:lnSpc>
        <a:spcBef>
          <a:spcPts val="475"/>
        </a:spcBef>
        <a:buFont typeface="Arial" panose="020B0604020202020204" pitchFamily="34" charset="0"/>
        <a:buChar char="•"/>
        <a:defRPr sz="1710" kern="1200">
          <a:solidFill>
            <a:schemeClr val="tx1"/>
          </a:solidFill>
          <a:latin typeface="+mn-lt"/>
          <a:ea typeface="+mn-ea"/>
          <a:cs typeface="+mn-cs"/>
        </a:defRPr>
      </a:lvl5pPr>
      <a:lvl6pPr marL="2388870" indent="-217170" algn="l" defTabSz="868680" rtl="0" eaLnBrk="1" latinLnBrk="0" hangingPunct="1">
        <a:lnSpc>
          <a:spcPct val="90000"/>
        </a:lnSpc>
        <a:spcBef>
          <a:spcPts val="475"/>
        </a:spcBef>
        <a:buFont typeface="Arial" panose="020B0604020202020204" pitchFamily="34" charset="0"/>
        <a:buChar char="•"/>
        <a:defRPr sz="1710" kern="1200">
          <a:solidFill>
            <a:schemeClr val="tx1"/>
          </a:solidFill>
          <a:latin typeface="+mn-lt"/>
          <a:ea typeface="+mn-ea"/>
          <a:cs typeface="+mn-cs"/>
        </a:defRPr>
      </a:lvl6pPr>
      <a:lvl7pPr marL="2823210" indent="-217170" algn="l" defTabSz="868680" rtl="0" eaLnBrk="1" latinLnBrk="0" hangingPunct="1">
        <a:lnSpc>
          <a:spcPct val="90000"/>
        </a:lnSpc>
        <a:spcBef>
          <a:spcPts val="475"/>
        </a:spcBef>
        <a:buFont typeface="Arial" panose="020B0604020202020204" pitchFamily="34" charset="0"/>
        <a:buChar char="•"/>
        <a:defRPr sz="1710" kern="1200">
          <a:solidFill>
            <a:schemeClr val="tx1"/>
          </a:solidFill>
          <a:latin typeface="+mn-lt"/>
          <a:ea typeface="+mn-ea"/>
          <a:cs typeface="+mn-cs"/>
        </a:defRPr>
      </a:lvl7pPr>
      <a:lvl8pPr marL="3257550" indent="-217170" algn="l" defTabSz="868680" rtl="0" eaLnBrk="1" latinLnBrk="0" hangingPunct="1">
        <a:lnSpc>
          <a:spcPct val="90000"/>
        </a:lnSpc>
        <a:spcBef>
          <a:spcPts val="475"/>
        </a:spcBef>
        <a:buFont typeface="Arial" panose="020B0604020202020204" pitchFamily="34" charset="0"/>
        <a:buChar char="•"/>
        <a:defRPr sz="1710" kern="1200">
          <a:solidFill>
            <a:schemeClr val="tx1"/>
          </a:solidFill>
          <a:latin typeface="+mn-lt"/>
          <a:ea typeface="+mn-ea"/>
          <a:cs typeface="+mn-cs"/>
        </a:defRPr>
      </a:lvl8pPr>
      <a:lvl9pPr marL="3691890" indent="-217170" algn="l" defTabSz="868680" rtl="0" eaLnBrk="1" latinLnBrk="0" hangingPunct="1">
        <a:lnSpc>
          <a:spcPct val="90000"/>
        </a:lnSpc>
        <a:spcBef>
          <a:spcPts val="475"/>
        </a:spcBef>
        <a:buFont typeface="Arial" panose="020B0604020202020204" pitchFamily="34" charset="0"/>
        <a:buChar char="•"/>
        <a:defRPr sz="171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8680" rtl="0" eaLnBrk="1" latinLnBrk="0" hangingPunct="1">
        <a:defRPr sz="1710" kern="1200">
          <a:solidFill>
            <a:schemeClr val="tx1"/>
          </a:solidFill>
          <a:latin typeface="+mn-lt"/>
          <a:ea typeface="+mn-ea"/>
          <a:cs typeface="+mn-cs"/>
        </a:defRPr>
      </a:lvl1pPr>
      <a:lvl2pPr marL="434340" algn="l" defTabSz="868680" rtl="0" eaLnBrk="1" latinLnBrk="0" hangingPunct="1">
        <a:defRPr sz="1710" kern="1200">
          <a:solidFill>
            <a:schemeClr val="tx1"/>
          </a:solidFill>
          <a:latin typeface="+mn-lt"/>
          <a:ea typeface="+mn-ea"/>
          <a:cs typeface="+mn-cs"/>
        </a:defRPr>
      </a:lvl2pPr>
      <a:lvl3pPr marL="868680" algn="l" defTabSz="868680" rtl="0" eaLnBrk="1" latinLnBrk="0" hangingPunct="1">
        <a:defRPr sz="1710" kern="1200">
          <a:solidFill>
            <a:schemeClr val="tx1"/>
          </a:solidFill>
          <a:latin typeface="+mn-lt"/>
          <a:ea typeface="+mn-ea"/>
          <a:cs typeface="+mn-cs"/>
        </a:defRPr>
      </a:lvl3pPr>
      <a:lvl4pPr marL="1303020" algn="l" defTabSz="868680" rtl="0" eaLnBrk="1" latinLnBrk="0" hangingPunct="1">
        <a:defRPr sz="1710" kern="1200">
          <a:solidFill>
            <a:schemeClr val="tx1"/>
          </a:solidFill>
          <a:latin typeface="+mn-lt"/>
          <a:ea typeface="+mn-ea"/>
          <a:cs typeface="+mn-cs"/>
        </a:defRPr>
      </a:lvl4pPr>
      <a:lvl5pPr marL="1737360" algn="l" defTabSz="868680" rtl="0" eaLnBrk="1" latinLnBrk="0" hangingPunct="1">
        <a:defRPr sz="1710" kern="1200">
          <a:solidFill>
            <a:schemeClr val="tx1"/>
          </a:solidFill>
          <a:latin typeface="+mn-lt"/>
          <a:ea typeface="+mn-ea"/>
          <a:cs typeface="+mn-cs"/>
        </a:defRPr>
      </a:lvl5pPr>
      <a:lvl6pPr marL="2171700" algn="l" defTabSz="868680" rtl="0" eaLnBrk="1" latinLnBrk="0" hangingPunct="1">
        <a:defRPr sz="1710" kern="1200">
          <a:solidFill>
            <a:schemeClr val="tx1"/>
          </a:solidFill>
          <a:latin typeface="+mn-lt"/>
          <a:ea typeface="+mn-ea"/>
          <a:cs typeface="+mn-cs"/>
        </a:defRPr>
      </a:lvl6pPr>
      <a:lvl7pPr marL="2606040" algn="l" defTabSz="868680" rtl="0" eaLnBrk="1" latinLnBrk="0" hangingPunct="1">
        <a:defRPr sz="1710" kern="1200">
          <a:solidFill>
            <a:schemeClr val="tx1"/>
          </a:solidFill>
          <a:latin typeface="+mn-lt"/>
          <a:ea typeface="+mn-ea"/>
          <a:cs typeface="+mn-cs"/>
        </a:defRPr>
      </a:lvl7pPr>
      <a:lvl8pPr marL="3040380" algn="l" defTabSz="868680" rtl="0" eaLnBrk="1" latinLnBrk="0" hangingPunct="1">
        <a:defRPr sz="1710" kern="1200">
          <a:solidFill>
            <a:schemeClr val="tx1"/>
          </a:solidFill>
          <a:latin typeface="+mn-lt"/>
          <a:ea typeface="+mn-ea"/>
          <a:cs typeface="+mn-cs"/>
        </a:defRPr>
      </a:lvl8pPr>
      <a:lvl9pPr marL="3474720" algn="l" defTabSz="868680" rtl="0" eaLnBrk="1" latinLnBrk="0" hangingPunct="1">
        <a:defRPr sz="171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2F2F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ounded Rectangle 13">
            <a:extLst>
              <a:ext uri="{FF2B5EF4-FFF2-40B4-BE49-F238E27FC236}">
                <a16:creationId xmlns:a16="http://schemas.microsoft.com/office/drawing/2014/main" id="{738B7597-617E-77F5-A69F-ECD38892A186}"/>
              </a:ext>
            </a:extLst>
          </p:cNvPr>
          <p:cNvSpPr>
            <a:spLocks noGrp="1" noRot="1" noMove="1" noResize="1" noEditPoints="1" noAdjustHandles="1" noChangeArrowheads="1" noChangeShapeType="1"/>
          </p:cNvSpPr>
          <p:nvPr/>
        </p:nvSpPr>
        <p:spPr>
          <a:xfrm>
            <a:off x="845127" y="4103517"/>
            <a:ext cx="7093528" cy="5609946"/>
          </a:xfrm>
          <a:prstGeom prst="roundRect">
            <a:avLst>
              <a:gd name="adj" fmla="val 3220"/>
            </a:avLst>
          </a:prstGeom>
          <a:solidFill>
            <a:schemeClr val="bg1"/>
          </a:solidFill>
          <a:ln w="3175"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54" name="Group 53">
            <a:extLst>
              <a:ext uri="{FF2B5EF4-FFF2-40B4-BE49-F238E27FC236}">
                <a16:creationId xmlns:a16="http://schemas.microsoft.com/office/drawing/2014/main" id="{3A172DF9-4963-3B26-1FBA-FB1FE3C74926}"/>
              </a:ext>
            </a:extLst>
          </p:cNvPr>
          <p:cNvGrpSpPr/>
          <p:nvPr/>
        </p:nvGrpSpPr>
        <p:grpSpPr>
          <a:xfrm>
            <a:off x="3439258" y="6304415"/>
            <a:ext cx="1972979" cy="1973481"/>
            <a:chOff x="2360031" y="5804950"/>
            <a:chExt cx="1972979" cy="1973481"/>
          </a:xfrm>
        </p:grpSpPr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2EDC4BB6-59DE-F2BB-88C2-2274EACCBA7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524990" y="5974114"/>
              <a:ext cx="1808020" cy="1804317"/>
            </a:xfrm>
            <a:prstGeom prst="rect">
              <a:avLst/>
            </a:prstGeom>
            <a:solidFill>
              <a:srgbClr val="E0F2F8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0969AFC9-AA37-2D27-F33F-D71B84DD53F6}"/>
                </a:ext>
              </a:extLst>
            </p:cNvPr>
            <p:cNvSpPr txBox="1"/>
            <p:nvPr/>
          </p:nvSpPr>
          <p:spPr>
            <a:xfrm>
              <a:off x="2566947" y="6028807"/>
              <a:ext cx="1724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/>
                <a:t>Iceberg</a:t>
              </a:r>
            </a:p>
            <a:p>
              <a:r>
                <a:rPr lang="en-US" sz="600" dirty="0"/>
                <a:t>Something that can stop the project (even in a later point)</a:t>
              </a:r>
            </a:p>
          </p:txBody>
        </p:sp>
        <p:sp>
          <p:nvSpPr>
            <p:cNvPr id="46" name="Oval 45">
              <a:extLst>
                <a:ext uri="{FF2B5EF4-FFF2-40B4-BE49-F238E27FC236}">
                  <a16:creationId xmlns:a16="http://schemas.microsoft.com/office/drawing/2014/main" id="{C6B3F5D3-8DCB-30D0-A70E-7CA0898CAE9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360031" y="5804950"/>
              <a:ext cx="329917" cy="338328"/>
            </a:xfrm>
            <a:prstGeom prst="ellipse">
              <a:avLst/>
            </a:prstGeom>
            <a:solidFill>
              <a:srgbClr val="A7CDF4"/>
            </a:solidFill>
            <a:ln w="3175">
              <a:solidFill>
                <a:srgbClr val="88AACD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47" name="Graphic 46" descr="Iceberg with solid fill">
              <a:extLst>
                <a:ext uri="{FF2B5EF4-FFF2-40B4-BE49-F238E27FC236}">
                  <a16:creationId xmlns:a16="http://schemas.microsoft.com/office/drawing/2014/main" id="{669C6E77-345C-B931-5D3A-E4992ACAD1F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2419103" y="5868228"/>
              <a:ext cx="211772" cy="211772"/>
            </a:xfrm>
            <a:prstGeom prst="rect">
              <a:avLst/>
            </a:prstGeom>
          </p:spPr>
        </p:pic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DD552F90-0FEE-2C86-2D4F-8A63FF8D0836}"/>
              </a:ext>
            </a:extLst>
          </p:cNvPr>
          <p:cNvGrpSpPr/>
          <p:nvPr/>
        </p:nvGrpSpPr>
        <p:grpSpPr>
          <a:xfrm>
            <a:off x="962420" y="4201057"/>
            <a:ext cx="2036211" cy="1911300"/>
            <a:chOff x="190089" y="3748771"/>
            <a:chExt cx="2036211" cy="1911300"/>
          </a:xfrm>
        </p:grpSpPr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13762307-DC0A-F023-9F74-F45506A137F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59108" y="3855754"/>
              <a:ext cx="1808020" cy="1804317"/>
            </a:xfrm>
            <a:prstGeom prst="rect">
              <a:avLst/>
            </a:prstGeom>
            <a:solidFill>
              <a:srgbClr val="BCD9F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0B33028-FB1D-DE86-BE8E-1AE9BFDE0908}"/>
                </a:ext>
              </a:extLst>
            </p:cNvPr>
            <p:cNvSpPr txBox="1"/>
            <p:nvPr/>
          </p:nvSpPr>
          <p:spPr>
            <a:xfrm>
              <a:off x="502194" y="3910302"/>
              <a:ext cx="1724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/>
                <a:t>Wind</a:t>
              </a:r>
            </a:p>
            <a:p>
              <a:r>
                <a:rPr lang="en-US" sz="600" dirty="0"/>
                <a:t>Things that help the project to propel forward to reach its goals</a:t>
              </a:r>
            </a:p>
          </p:txBody>
        </p:sp>
        <p:sp>
          <p:nvSpPr>
            <p:cNvPr id="41" name="Oval 40">
              <a:extLst>
                <a:ext uri="{FF2B5EF4-FFF2-40B4-BE49-F238E27FC236}">
                  <a16:creationId xmlns:a16="http://schemas.microsoft.com/office/drawing/2014/main" id="{AB715D77-04CB-0F5F-93F5-9CD6DD9E9D6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90089" y="3748771"/>
              <a:ext cx="329917" cy="338328"/>
            </a:xfrm>
            <a:prstGeom prst="ellipse">
              <a:avLst/>
            </a:prstGeom>
            <a:solidFill>
              <a:srgbClr val="6476D0"/>
            </a:solidFill>
            <a:ln w="3175">
              <a:solidFill>
                <a:srgbClr val="6476D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42" name="Graphic 41" descr="Windy with solid fill">
              <a:extLst>
                <a:ext uri="{FF2B5EF4-FFF2-40B4-BE49-F238E27FC236}">
                  <a16:creationId xmlns:a16="http://schemas.microsoft.com/office/drawing/2014/main" id="{37D9F86D-DAE9-5E31-AFA6-D36C334AFF4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229297" y="3792185"/>
              <a:ext cx="251501" cy="251501"/>
            </a:xfrm>
            <a:prstGeom prst="rect">
              <a:avLst/>
            </a:prstGeom>
          </p:spPr>
        </p:pic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A321DB8E-CF76-35EB-94BB-29A32A49F2EB}"/>
              </a:ext>
            </a:extLst>
          </p:cNvPr>
          <p:cNvGrpSpPr/>
          <p:nvPr/>
        </p:nvGrpSpPr>
        <p:grpSpPr>
          <a:xfrm>
            <a:off x="5781539" y="4208832"/>
            <a:ext cx="2009037" cy="1935294"/>
            <a:chOff x="4489855" y="3748771"/>
            <a:chExt cx="2009037" cy="1935294"/>
          </a:xfrm>
        </p:grpSpPr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D47BD01A-3433-6EB1-2B55-D729F891D68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690872" y="3879748"/>
              <a:ext cx="1808020" cy="1804317"/>
            </a:xfrm>
            <a:prstGeom prst="rect">
              <a:avLst/>
            </a:prstGeom>
            <a:solidFill>
              <a:srgbClr val="DBEEC9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E4CD50E-6131-301D-52DB-D3E5073FFA3C}"/>
                </a:ext>
              </a:extLst>
            </p:cNvPr>
            <p:cNvSpPr txBox="1"/>
            <p:nvPr/>
          </p:nvSpPr>
          <p:spPr>
            <a:xfrm>
              <a:off x="4774786" y="3922547"/>
              <a:ext cx="1724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/>
                <a:t>Anchors</a:t>
              </a:r>
            </a:p>
            <a:p>
              <a:r>
                <a:rPr lang="en-US" sz="600" dirty="0"/>
                <a:t>Everything that slows the project down or holds it back</a:t>
              </a:r>
            </a:p>
          </p:txBody>
        </p: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AE9B47F9-5716-BE01-2BAB-3B4ABB276E94}"/>
                </a:ext>
              </a:extLst>
            </p:cNvPr>
            <p:cNvGrpSpPr/>
            <p:nvPr/>
          </p:nvGrpSpPr>
          <p:grpSpPr>
            <a:xfrm>
              <a:off x="4489855" y="3748771"/>
              <a:ext cx="329917" cy="338328"/>
              <a:chOff x="4489855" y="3748771"/>
              <a:chExt cx="329917" cy="338328"/>
            </a:xfrm>
          </p:grpSpPr>
          <p:sp>
            <p:nvSpPr>
              <p:cNvPr id="43" name="Oval 42">
                <a:extLst>
                  <a:ext uri="{FF2B5EF4-FFF2-40B4-BE49-F238E27FC236}">
                    <a16:creationId xmlns:a16="http://schemas.microsoft.com/office/drawing/2014/main" id="{9E29BFC5-99C5-19FB-6DAD-1A0859BBA85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489855" y="3748771"/>
                <a:ext cx="329917" cy="338328"/>
              </a:xfrm>
              <a:prstGeom prst="ellipse">
                <a:avLst/>
              </a:prstGeom>
              <a:solidFill>
                <a:srgbClr val="59A09C"/>
              </a:solidFill>
              <a:ln w="3175">
                <a:solidFill>
                  <a:srgbClr val="62A8A4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pic>
            <p:nvPicPr>
              <p:cNvPr id="44" name="Graphic 43" descr="Anchor with solid fill">
                <a:extLst>
                  <a:ext uri="{FF2B5EF4-FFF2-40B4-BE49-F238E27FC236}">
                    <a16:creationId xmlns:a16="http://schemas.microsoft.com/office/drawing/2014/main" id="{32071AD4-C02F-1CD0-2500-4A17664373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96DAC541-7B7A-43D3-8B79-37D633B846F1}">
                    <asvg:svgBlip xmlns:asvg="http://schemas.microsoft.com/office/drawing/2016/SVG/main" r:embed="rId7"/>
                  </a:ext>
                </a:extLst>
              </a:blip>
              <a:stretch>
                <a:fillRect/>
              </a:stretch>
            </p:blipFill>
            <p:spPr>
              <a:xfrm>
                <a:off x="4563448" y="3826570"/>
                <a:ext cx="182730" cy="182730"/>
              </a:xfrm>
              <a:prstGeom prst="rect">
                <a:avLst/>
              </a:prstGeom>
            </p:spPr>
          </p:pic>
        </p:grpSp>
      </p:grpSp>
      <p:sp>
        <p:nvSpPr>
          <p:cNvPr id="16" name="Folded Corner 15">
            <a:extLst>
              <a:ext uri="{FF2B5EF4-FFF2-40B4-BE49-F238E27FC236}">
                <a16:creationId xmlns:a16="http://schemas.microsoft.com/office/drawing/2014/main" id="{4C1B3B59-D432-D4CD-0EDD-D36C9F9CD259}"/>
              </a:ext>
            </a:extLst>
          </p:cNvPr>
          <p:cNvSpPr>
            <a:spLocks noChangeAspect="1"/>
          </p:cNvSpPr>
          <p:nvPr/>
        </p:nvSpPr>
        <p:spPr>
          <a:xfrm>
            <a:off x="1295054" y="4886598"/>
            <a:ext cx="597855" cy="616538"/>
          </a:xfrm>
          <a:prstGeom prst="foldedCorner">
            <a:avLst/>
          </a:prstGeom>
          <a:solidFill>
            <a:srgbClr val="7F96FE"/>
          </a:solidFill>
          <a:ln w="3175">
            <a:solidFill>
              <a:srgbClr val="5A6ABB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sp>
        <p:nvSpPr>
          <p:cNvPr id="18" name="Folded Corner 17">
            <a:extLst>
              <a:ext uri="{FF2B5EF4-FFF2-40B4-BE49-F238E27FC236}">
                <a16:creationId xmlns:a16="http://schemas.microsoft.com/office/drawing/2014/main" id="{A5E931E6-03FA-8C0F-270D-F19F086D5EEA}"/>
              </a:ext>
            </a:extLst>
          </p:cNvPr>
          <p:cNvSpPr>
            <a:spLocks noChangeAspect="1"/>
          </p:cNvSpPr>
          <p:nvPr/>
        </p:nvSpPr>
        <p:spPr>
          <a:xfrm>
            <a:off x="2149443" y="4842063"/>
            <a:ext cx="597855" cy="616538"/>
          </a:xfrm>
          <a:prstGeom prst="foldedCorner">
            <a:avLst/>
          </a:prstGeom>
          <a:solidFill>
            <a:srgbClr val="7F96FE"/>
          </a:solidFill>
          <a:ln w="3175">
            <a:solidFill>
              <a:srgbClr val="5A6ABB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sp>
        <p:nvSpPr>
          <p:cNvPr id="19" name="Folded Corner 18">
            <a:extLst>
              <a:ext uri="{FF2B5EF4-FFF2-40B4-BE49-F238E27FC236}">
                <a16:creationId xmlns:a16="http://schemas.microsoft.com/office/drawing/2014/main" id="{90D8D86B-0813-7092-22C5-D94B41083493}"/>
              </a:ext>
            </a:extLst>
          </p:cNvPr>
          <p:cNvSpPr>
            <a:spLocks noChangeAspect="1"/>
          </p:cNvSpPr>
          <p:nvPr/>
        </p:nvSpPr>
        <p:spPr>
          <a:xfrm>
            <a:off x="1917517" y="5530584"/>
            <a:ext cx="597855" cy="616538"/>
          </a:xfrm>
          <a:prstGeom prst="foldedCorner">
            <a:avLst/>
          </a:prstGeom>
          <a:solidFill>
            <a:srgbClr val="7F96FE"/>
          </a:solidFill>
          <a:ln w="3175">
            <a:solidFill>
              <a:srgbClr val="5A6ABB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sp>
        <p:nvSpPr>
          <p:cNvPr id="21" name="Folded Corner 20">
            <a:extLst>
              <a:ext uri="{FF2B5EF4-FFF2-40B4-BE49-F238E27FC236}">
                <a16:creationId xmlns:a16="http://schemas.microsoft.com/office/drawing/2014/main" id="{482A7913-4FA8-7AC6-F7DF-8A1D95BD2A82}"/>
              </a:ext>
            </a:extLst>
          </p:cNvPr>
          <p:cNvSpPr>
            <a:spLocks noChangeAspect="1"/>
          </p:cNvSpPr>
          <p:nvPr/>
        </p:nvSpPr>
        <p:spPr>
          <a:xfrm>
            <a:off x="6189536" y="4907596"/>
            <a:ext cx="597855" cy="616538"/>
          </a:xfrm>
          <a:prstGeom prst="foldedCorner">
            <a:avLst/>
          </a:prstGeom>
          <a:solidFill>
            <a:srgbClr val="7CCEC8"/>
          </a:solidFill>
          <a:ln w="3175">
            <a:solidFill>
              <a:srgbClr val="59A09C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sp>
        <p:nvSpPr>
          <p:cNvPr id="22" name="Folded Corner 21">
            <a:extLst>
              <a:ext uri="{FF2B5EF4-FFF2-40B4-BE49-F238E27FC236}">
                <a16:creationId xmlns:a16="http://schemas.microsoft.com/office/drawing/2014/main" id="{25B68643-39C2-AC9F-BEFA-FC079471077C}"/>
              </a:ext>
            </a:extLst>
          </p:cNvPr>
          <p:cNvSpPr>
            <a:spLocks noChangeAspect="1"/>
          </p:cNvSpPr>
          <p:nvPr/>
        </p:nvSpPr>
        <p:spPr>
          <a:xfrm>
            <a:off x="7043925" y="4863061"/>
            <a:ext cx="597855" cy="616538"/>
          </a:xfrm>
          <a:prstGeom prst="foldedCorner">
            <a:avLst/>
          </a:prstGeom>
          <a:solidFill>
            <a:srgbClr val="7CCEC8"/>
          </a:solidFill>
          <a:ln w="3175">
            <a:solidFill>
              <a:srgbClr val="59A09C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sp>
        <p:nvSpPr>
          <p:cNvPr id="23" name="Folded Corner 22">
            <a:extLst>
              <a:ext uri="{FF2B5EF4-FFF2-40B4-BE49-F238E27FC236}">
                <a16:creationId xmlns:a16="http://schemas.microsoft.com/office/drawing/2014/main" id="{0059789E-1FA2-7867-82D0-5529FFFC51D6}"/>
              </a:ext>
            </a:extLst>
          </p:cNvPr>
          <p:cNvSpPr>
            <a:spLocks noChangeAspect="1"/>
          </p:cNvSpPr>
          <p:nvPr/>
        </p:nvSpPr>
        <p:spPr>
          <a:xfrm>
            <a:off x="6744997" y="5695490"/>
            <a:ext cx="597855" cy="616538"/>
          </a:xfrm>
          <a:prstGeom prst="foldedCorner">
            <a:avLst/>
          </a:prstGeom>
          <a:solidFill>
            <a:srgbClr val="7CCEC8"/>
          </a:solidFill>
          <a:ln w="3175">
            <a:solidFill>
              <a:srgbClr val="59A09C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sp>
        <p:nvSpPr>
          <p:cNvPr id="25" name="Folded Corner 24">
            <a:extLst>
              <a:ext uri="{FF2B5EF4-FFF2-40B4-BE49-F238E27FC236}">
                <a16:creationId xmlns:a16="http://schemas.microsoft.com/office/drawing/2014/main" id="{57C5D8F1-6F16-C7A5-8696-83027210549B}"/>
              </a:ext>
            </a:extLst>
          </p:cNvPr>
          <p:cNvSpPr>
            <a:spLocks noChangeAspect="1"/>
          </p:cNvSpPr>
          <p:nvPr/>
        </p:nvSpPr>
        <p:spPr>
          <a:xfrm>
            <a:off x="3811197" y="7041360"/>
            <a:ext cx="597855" cy="616538"/>
          </a:xfrm>
          <a:prstGeom prst="foldedCorner">
            <a:avLst/>
          </a:prstGeom>
          <a:solidFill>
            <a:srgbClr val="A7CDF4"/>
          </a:solidFill>
          <a:ln w="3175">
            <a:solidFill>
              <a:srgbClr val="8FAFD2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sp>
        <p:nvSpPr>
          <p:cNvPr id="26" name="Folded Corner 25">
            <a:extLst>
              <a:ext uri="{FF2B5EF4-FFF2-40B4-BE49-F238E27FC236}">
                <a16:creationId xmlns:a16="http://schemas.microsoft.com/office/drawing/2014/main" id="{7AB3D05B-6C5B-5BE5-BD10-F1F47B4043F1}"/>
              </a:ext>
            </a:extLst>
          </p:cNvPr>
          <p:cNvSpPr>
            <a:spLocks noChangeAspect="1"/>
          </p:cNvSpPr>
          <p:nvPr/>
        </p:nvSpPr>
        <p:spPr>
          <a:xfrm>
            <a:off x="4665586" y="6996825"/>
            <a:ext cx="597855" cy="616538"/>
          </a:xfrm>
          <a:prstGeom prst="foldedCorner">
            <a:avLst/>
          </a:prstGeom>
          <a:solidFill>
            <a:srgbClr val="A7CDF4"/>
          </a:solidFill>
          <a:ln w="3175">
            <a:solidFill>
              <a:srgbClr val="8FAFD2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sp>
        <p:nvSpPr>
          <p:cNvPr id="27" name="Folded Corner 26">
            <a:extLst>
              <a:ext uri="{FF2B5EF4-FFF2-40B4-BE49-F238E27FC236}">
                <a16:creationId xmlns:a16="http://schemas.microsoft.com/office/drawing/2014/main" id="{F13582CF-4BD2-1C62-C135-8C4026E7DC28}"/>
              </a:ext>
            </a:extLst>
          </p:cNvPr>
          <p:cNvSpPr>
            <a:spLocks noChangeAspect="1"/>
          </p:cNvSpPr>
          <p:nvPr/>
        </p:nvSpPr>
        <p:spPr>
          <a:xfrm>
            <a:off x="4305727" y="7734769"/>
            <a:ext cx="597855" cy="616538"/>
          </a:xfrm>
          <a:prstGeom prst="foldedCorner">
            <a:avLst/>
          </a:prstGeom>
          <a:solidFill>
            <a:srgbClr val="A7CDF4"/>
          </a:solidFill>
          <a:ln w="3175">
            <a:solidFill>
              <a:srgbClr val="8FAFD2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grpSp>
        <p:nvGrpSpPr>
          <p:cNvPr id="55" name="Group 54">
            <a:extLst>
              <a:ext uri="{FF2B5EF4-FFF2-40B4-BE49-F238E27FC236}">
                <a16:creationId xmlns:a16="http://schemas.microsoft.com/office/drawing/2014/main" id="{B28DAB26-7A87-0666-D83B-DF194B693ED9}"/>
              </a:ext>
            </a:extLst>
          </p:cNvPr>
          <p:cNvGrpSpPr/>
          <p:nvPr/>
        </p:nvGrpSpPr>
        <p:grpSpPr>
          <a:xfrm>
            <a:off x="1526964" y="8621121"/>
            <a:ext cx="5920849" cy="784985"/>
            <a:chOff x="1141833" y="8066246"/>
            <a:chExt cx="4677409" cy="784985"/>
          </a:xfrm>
        </p:grpSpPr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D08D9426-C0EF-BDB2-7570-96DCEAF2231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141833" y="8066246"/>
              <a:ext cx="4677409" cy="784985"/>
            </a:xfrm>
            <a:prstGeom prst="rect">
              <a:avLst/>
            </a:prstGeom>
            <a:solidFill>
              <a:srgbClr val="FEDAA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135B23E-648C-44BF-F46D-81EF4748D867}"/>
                </a:ext>
              </a:extLst>
            </p:cNvPr>
            <p:cNvSpPr txBox="1"/>
            <p:nvPr/>
          </p:nvSpPr>
          <p:spPr>
            <a:xfrm>
              <a:off x="1263118" y="8139663"/>
              <a:ext cx="439106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/>
                <a:t>Action Plan</a:t>
              </a:r>
            </a:p>
            <a:p>
              <a:r>
                <a:rPr lang="en-US" sz="600" dirty="0"/>
                <a:t>Create an action plan using SMART (Specific, Measurable, Achievable, Relevant, and Time-Bound) format objectives</a:t>
              </a:r>
            </a:p>
            <a:p>
              <a:r>
                <a:rPr lang="en-US" sz="600" dirty="0"/>
                <a:t>1. </a:t>
              </a:r>
            </a:p>
            <a:p>
              <a:r>
                <a:rPr lang="en-US" sz="600" dirty="0"/>
                <a:t>2. </a:t>
              </a:r>
            </a:p>
            <a:p>
              <a:r>
                <a:rPr lang="en-US" sz="600" dirty="0"/>
                <a:t>3. </a:t>
              </a:r>
            </a:p>
            <a:p>
              <a:endParaRPr lang="en-US" sz="600" dirty="0"/>
            </a:p>
          </p:txBody>
        </p:sp>
      </p:grpSp>
      <p:grpSp>
        <p:nvGrpSpPr>
          <p:cNvPr id="56" name="Group 55">
            <a:extLst>
              <a:ext uri="{FF2B5EF4-FFF2-40B4-BE49-F238E27FC236}">
                <a16:creationId xmlns:a16="http://schemas.microsoft.com/office/drawing/2014/main" id="{E46A2E64-B089-710B-501C-61C6F86EDE17}"/>
              </a:ext>
            </a:extLst>
          </p:cNvPr>
          <p:cNvGrpSpPr/>
          <p:nvPr/>
        </p:nvGrpSpPr>
        <p:grpSpPr>
          <a:xfrm>
            <a:off x="6144561" y="6720642"/>
            <a:ext cx="841749" cy="868054"/>
            <a:chOff x="4678566" y="5974114"/>
            <a:chExt cx="841749" cy="868054"/>
          </a:xfrm>
        </p:grpSpPr>
        <p:sp>
          <p:nvSpPr>
            <p:cNvPr id="28" name="Folded Corner 27">
              <a:extLst>
                <a:ext uri="{FF2B5EF4-FFF2-40B4-BE49-F238E27FC236}">
                  <a16:creationId xmlns:a16="http://schemas.microsoft.com/office/drawing/2014/main" id="{0D2209DB-67F1-3DB9-23E6-21423436C6D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678566" y="5974114"/>
              <a:ext cx="841749" cy="868054"/>
            </a:xfrm>
            <a:prstGeom prst="foldedCorner">
              <a:avLst/>
            </a:prstGeom>
            <a:solidFill>
              <a:srgbClr val="FE9D4B"/>
            </a:solidFill>
            <a:ln w="3175">
              <a:solidFill>
                <a:srgbClr val="E58C45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dirty="0">
                <a:solidFill>
                  <a:schemeClr val="tx1"/>
                </a:solidFill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17E015C8-EC30-1770-4AAC-D3FD5D6E83BD}"/>
                </a:ext>
              </a:extLst>
            </p:cNvPr>
            <p:cNvSpPr txBox="1"/>
            <p:nvPr/>
          </p:nvSpPr>
          <p:spPr>
            <a:xfrm>
              <a:off x="4703174" y="5997950"/>
              <a:ext cx="817141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/>
                <a:t>Questions</a:t>
              </a:r>
            </a:p>
            <a:p>
              <a:r>
                <a:rPr lang="en-US" sz="700" dirty="0"/>
                <a:t>1. </a:t>
              </a:r>
            </a:p>
            <a:p>
              <a:r>
                <a:rPr lang="en-US" sz="700" dirty="0"/>
                <a:t>2. </a:t>
              </a:r>
            </a:p>
            <a:p>
              <a:r>
                <a:rPr lang="en-US" sz="700" dirty="0"/>
                <a:t>3. </a:t>
              </a:r>
            </a:p>
            <a:p>
              <a:endParaRPr lang="en-US" sz="700" dirty="0"/>
            </a:p>
          </p:txBody>
        </p:sp>
      </p:grpSp>
      <p:sp>
        <p:nvSpPr>
          <p:cNvPr id="64" name="Rectangle 63">
            <a:extLst>
              <a:ext uri="{FF2B5EF4-FFF2-40B4-BE49-F238E27FC236}">
                <a16:creationId xmlns:a16="http://schemas.microsoft.com/office/drawing/2014/main" id="{6CD28FA2-0201-4D38-16C2-EA248B4DE6E9}"/>
              </a:ext>
            </a:extLst>
          </p:cNvPr>
          <p:cNvSpPr>
            <a:spLocks/>
          </p:cNvSpPr>
          <p:nvPr/>
        </p:nvSpPr>
        <p:spPr>
          <a:xfrm>
            <a:off x="3176536" y="4485565"/>
            <a:ext cx="2547229" cy="1642449"/>
          </a:xfrm>
          <a:custGeom>
            <a:avLst/>
            <a:gdLst>
              <a:gd name="connsiteX0" fmla="*/ 0 w 2547229"/>
              <a:gd name="connsiteY0" fmla="*/ 0 h 1642449"/>
              <a:gd name="connsiteX1" fmla="*/ 687752 w 2547229"/>
              <a:gd name="connsiteY1" fmla="*/ 0 h 1642449"/>
              <a:gd name="connsiteX2" fmla="*/ 1350031 w 2547229"/>
              <a:gd name="connsiteY2" fmla="*/ 0 h 1642449"/>
              <a:gd name="connsiteX3" fmla="*/ 2547229 w 2547229"/>
              <a:gd name="connsiteY3" fmla="*/ 0 h 1642449"/>
              <a:gd name="connsiteX4" fmla="*/ 2547229 w 2547229"/>
              <a:gd name="connsiteY4" fmla="*/ 498210 h 1642449"/>
              <a:gd name="connsiteX5" fmla="*/ 2547229 w 2547229"/>
              <a:gd name="connsiteY5" fmla="*/ 1078542 h 1642449"/>
              <a:gd name="connsiteX6" fmla="*/ 2547229 w 2547229"/>
              <a:gd name="connsiteY6" fmla="*/ 1642449 h 1642449"/>
              <a:gd name="connsiteX7" fmla="*/ 1961366 w 2547229"/>
              <a:gd name="connsiteY7" fmla="*/ 1642449 h 1642449"/>
              <a:gd name="connsiteX8" fmla="*/ 1350031 w 2547229"/>
              <a:gd name="connsiteY8" fmla="*/ 1642449 h 1642449"/>
              <a:gd name="connsiteX9" fmla="*/ 789641 w 2547229"/>
              <a:gd name="connsiteY9" fmla="*/ 1642449 h 1642449"/>
              <a:gd name="connsiteX10" fmla="*/ 0 w 2547229"/>
              <a:gd name="connsiteY10" fmla="*/ 1642449 h 1642449"/>
              <a:gd name="connsiteX11" fmla="*/ 0 w 2547229"/>
              <a:gd name="connsiteY11" fmla="*/ 1078542 h 1642449"/>
              <a:gd name="connsiteX12" fmla="*/ 0 w 2547229"/>
              <a:gd name="connsiteY12" fmla="*/ 580332 h 1642449"/>
              <a:gd name="connsiteX13" fmla="*/ 0 w 2547229"/>
              <a:gd name="connsiteY13" fmla="*/ 0 h 164244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2547229" h="1642449" fill="none" extrusionOk="0">
                <a:moveTo>
                  <a:pt x="0" y="0"/>
                </a:moveTo>
                <a:cubicBezTo>
                  <a:pt x="325424" y="-23027"/>
                  <a:pt x="365124" y="28164"/>
                  <a:pt x="687752" y="0"/>
                </a:cubicBezTo>
                <a:cubicBezTo>
                  <a:pt x="1010380" y="-28164"/>
                  <a:pt x="1135031" y="31141"/>
                  <a:pt x="1350031" y="0"/>
                </a:cubicBezTo>
                <a:cubicBezTo>
                  <a:pt x="1565031" y="-31141"/>
                  <a:pt x="2175744" y="-32168"/>
                  <a:pt x="2547229" y="0"/>
                </a:cubicBezTo>
                <a:cubicBezTo>
                  <a:pt x="2551391" y="191893"/>
                  <a:pt x="2565830" y="262210"/>
                  <a:pt x="2547229" y="498210"/>
                </a:cubicBezTo>
                <a:cubicBezTo>
                  <a:pt x="2528629" y="734210"/>
                  <a:pt x="2573659" y="866972"/>
                  <a:pt x="2547229" y="1078542"/>
                </a:cubicBezTo>
                <a:cubicBezTo>
                  <a:pt x="2520799" y="1290112"/>
                  <a:pt x="2525193" y="1450412"/>
                  <a:pt x="2547229" y="1642449"/>
                </a:cubicBezTo>
                <a:cubicBezTo>
                  <a:pt x="2355642" y="1661067"/>
                  <a:pt x="2250314" y="1621136"/>
                  <a:pt x="1961366" y="1642449"/>
                </a:cubicBezTo>
                <a:cubicBezTo>
                  <a:pt x="1672418" y="1663762"/>
                  <a:pt x="1600128" y="1629959"/>
                  <a:pt x="1350031" y="1642449"/>
                </a:cubicBezTo>
                <a:cubicBezTo>
                  <a:pt x="1099934" y="1654939"/>
                  <a:pt x="1054394" y="1638243"/>
                  <a:pt x="789641" y="1642449"/>
                </a:cubicBezTo>
                <a:cubicBezTo>
                  <a:pt x="524888" y="1646656"/>
                  <a:pt x="299126" y="1627472"/>
                  <a:pt x="0" y="1642449"/>
                </a:cubicBezTo>
                <a:cubicBezTo>
                  <a:pt x="21204" y="1445694"/>
                  <a:pt x="15220" y="1263651"/>
                  <a:pt x="0" y="1078542"/>
                </a:cubicBezTo>
                <a:cubicBezTo>
                  <a:pt x="-15220" y="893433"/>
                  <a:pt x="-5299" y="796020"/>
                  <a:pt x="0" y="580332"/>
                </a:cubicBezTo>
                <a:cubicBezTo>
                  <a:pt x="5299" y="364644"/>
                  <a:pt x="-108" y="122678"/>
                  <a:pt x="0" y="0"/>
                </a:cubicBezTo>
                <a:close/>
              </a:path>
              <a:path w="2547229" h="1642449" stroke="0" extrusionOk="0">
                <a:moveTo>
                  <a:pt x="0" y="0"/>
                </a:moveTo>
                <a:cubicBezTo>
                  <a:pt x="190508" y="19255"/>
                  <a:pt x="316844" y="16270"/>
                  <a:pt x="611335" y="0"/>
                </a:cubicBezTo>
                <a:cubicBezTo>
                  <a:pt x="905827" y="-16270"/>
                  <a:pt x="956471" y="22607"/>
                  <a:pt x="1171725" y="0"/>
                </a:cubicBezTo>
                <a:cubicBezTo>
                  <a:pt x="1386979" y="-22607"/>
                  <a:pt x="1700282" y="-24164"/>
                  <a:pt x="1859477" y="0"/>
                </a:cubicBezTo>
                <a:cubicBezTo>
                  <a:pt x="2018672" y="24164"/>
                  <a:pt x="2265871" y="-4731"/>
                  <a:pt x="2547229" y="0"/>
                </a:cubicBezTo>
                <a:cubicBezTo>
                  <a:pt x="2553623" y="250865"/>
                  <a:pt x="2567924" y="295384"/>
                  <a:pt x="2547229" y="531059"/>
                </a:cubicBezTo>
                <a:cubicBezTo>
                  <a:pt x="2526534" y="766734"/>
                  <a:pt x="2571855" y="865137"/>
                  <a:pt x="2547229" y="1045693"/>
                </a:cubicBezTo>
                <a:cubicBezTo>
                  <a:pt x="2522603" y="1226249"/>
                  <a:pt x="2553795" y="1387078"/>
                  <a:pt x="2547229" y="1642449"/>
                </a:cubicBezTo>
                <a:cubicBezTo>
                  <a:pt x="2370544" y="1644645"/>
                  <a:pt x="2115330" y="1665450"/>
                  <a:pt x="1910422" y="1642449"/>
                </a:cubicBezTo>
                <a:cubicBezTo>
                  <a:pt x="1705514" y="1619448"/>
                  <a:pt x="1470309" y="1653754"/>
                  <a:pt x="1350031" y="1642449"/>
                </a:cubicBezTo>
                <a:cubicBezTo>
                  <a:pt x="1229753" y="1631144"/>
                  <a:pt x="979307" y="1671219"/>
                  <a:pt x="713224" y="1642449"/>
                </a:cubicBezTo>
                <a:cubicBezTo>
                  <a:pt x="447141" y="1613679"/>
                  <a:pt x="267897" y="1627863"/>
                  <a:pt x="0" y="1642449"/>
                </a:cubicBezTo>
                <a:cubicBezTo>
                  <a:pt x="2076" y="1430950"/>
                  <a:pt x="-20250" y="1225905"/>
                  <a:pt x="0" y="1111390"/>
                </a:cubicBezTo>
                <a:cubicBezTo>
                  <a:pt x="20250" y="996875"/>
                  <a:pt x="3077" y="844049"/>
                  <a:pt x="0" y="580332"/>
                </a:cubicBezTo>
                <a:cubicBezTo>
                  <a:pt x="-3077" y="316615"/>
                  <a:pt x="-24917" y="138909"/>
                  <a:pt x="0" y="0"/>
                </a:cubicBezTo>
                <a:close/>
              </a:path>
            </a:pathLst>
          </a:custGeom>
          <a:solidFill>
            <a:schemeClr val="bg1"/>
          </a:solidFill>
          <a:ln w="3175">
            <a:solidFill>
              <a:schemeClr val="tx1">
                <a:lumMod val="75000"/>
                <a:lumOff val="25000"/>
              </a:schemeClr>
            </a:solidFill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33B544A-B5FE-8514-CD4E-B5B074E38D72}"/>
              </a:ext>
            </a:extLst>
          </p:cNvPr>
          <p:cNvSpPr txBox="1"/>
          <p:nvPr/>
        </p:nvSpPr>
        <p:spPr>
          <a:xfrm>
            <a:off x="3659226" y="4888920"/>
            <a:ext cx="14977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Bradley Hand ITC" panose="03070402050302030203" pitchFamily="66" charset="77"/>
              </a:rPr>
              <a:t>Participant’s Sailboa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156DC0B-DAEF-4D03-9FE0-8371D3902FE6}"/>
              </a:ext>
            </a:extLst>
          </p:cNvPr>
          <p:cNvSpPr txBox="1"/>
          <p:nvPr/>
        </p:nvSpPr>
        <p:spPr>
          <a:xfrm>
            <a:off x="3621260" y="3814800"/>
            <a:ext cx="1343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articipant Name</a:t>
            </a:r>
          </a:p>
        </p:txBody>
      </p:sp>
      <p:sp>
        <p:nvSpPr>
          <p:cNvPr id="6" name="Rounded Rectangle 5">
            <a:extLst>
              <a:ext uri="{FF2B5EF4-FFF2-40B4-BE49-F238E27FC236}">
                <a16:creationId xmlns:a16="http://schemas.microsoft.com/office/drawing/2014/main" id="{B4065B2F-5E17-8147-2342-D1B62EB88EF4}"/>
              </a:ext>
            </a:extLst>
          </p:cNvPr>
          <p:cNvSpPr/>
          <p:nvPr/>
        </p:nvSpPr>
        <p:spPr>
          <a:xfrm>
            <a:off x="3221071" y="350062"/>
            <a:ext cx="2523744" cy="518086"/>
          </a:xfrm>
          <a:prstGeom prst="roundRect">
            <a:avLst/>
          </a:prstGeom>
          <a:solidFill>
            <a:schemeClr val="accent5">
              <a:lumMod val="40000"/>
              <a:lumOff val="60000"/>
            </a:schemeClr>
          </a:solidFill>
          <a:ln w="952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Group #</a:t>
            </a:r>
          </a:p>
        </p:txBody>
      </p:sp>
      <p:sp>
        <p:nvSpPr>
          <p:cNvPr id="7" name="Rounded Rectangular Callout 6">
            <a:extLst>
              <a:ext uri="{FF2B5EF4-FFF2-40B4-BE49-F238E27FC236}">
                <a16:creationId xmlns:a16="http://schemas.microsoft.com/office/drawing/2014/main" id="{B0676233-B869-270F-5CFF-8CEC3079AE95}"/>
              </a:ext>
            </a:extLst>
          </p:cNvPr>
          <p:cNvSpPr/>
          <p:nvPr/>
        </p:nvSpPr>
        <p:spPr>
          <a:xfrm>
            <a:off x="1230755" y="1575372"/>
            <a:ext cx="2909455" cy="1602957"/>
          </a:xfrm>
          <a:prstGeom prst="wedgeRoundRectCallout">
            <a:avLst>
              <a:gd name="adj1" fmla="val 44032"/>
              <a:gd name="adj2" fmla="val -73764"/>
              <a:gd name="adj3" fmla="val 16667"/>
            </a:avLst>
          </a:prstGeom>
          <a:solidFill>
            <a:schemeClr val="bg1"/>
          </a:solidFill>
          <a:ln w="9525"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1" name="Picture 10" descr="A screenshot of a smart goal&#10;&#10;Description automatically generated">
            <a:extLst>
              <a:ext uri="{FF2B5EF4-FFF2-40B4-BE49-F238E27FC236}">
                <a16:creationId xmlns:a16="http://schemas.microsoft.com/office/drawing/2014/main" id="{14C226A5-35D1-D342-19E6-662FF1AFF1B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39644" y="1323224"/>
            <a:ext cx="2523744" cy="1417484"/>
          </a:xfrm>
          <a:prstGeom prst="rect">
            <a:avLst/>
          </a:prstGeom>
          <a:ln>
            <a:solidFill>
              <a:schemeClr val="bg2">
                <a:lumMod val="50000"/>
              </a:schemeClr>
            </a:solidFill>
          </a:ln>
        </p:spPr>
      </p:pic>
      <p:cxnSp>
        <p:nvCxnSpPr>
          <p:cNvPr id="49" name="Curved Connector 48">
            <a:extLst>
              <a:ext uri="{FF2B5EF4-FFF2-40B4-BE49-F238E27FC236}">
                <a16:creationId xmlns:a16="http://schemas.microsoft.com/office/drawing/2014/main" id="{F2E7E03A-20AC-B8BA-3B05-3E4485EEDEB5}"/>
              </a:ext>
            </a:extLst>
          </p:cNvPr>
          <p:cNvCxnSpPr/>
          <p:nvPr/>
        </p:nvCxnSpPr>
        <p:spPr>
          <a:xfrm flipV="1">
            <a:off x="4140204" y="1780777"/>
            <a:ext cx="899440" cy="478173"/>
          </a:xfrm>
          <a:prstGeom prst="curvedConnector3">
            <a:avLst/>
          </a:prstGeom>
          <a:ln w="9525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3" name="Rounded Rectangle 72">
            <a:extLst>
              <a:ext uri="{FF2B5EF4-FFF2-40B4-BE49-F238E27FC236}">
                <a16:creationId xmlns:a16="http://schemas.microsoft.com/office/drawing/2014/main" id="{9B6691E3-C174-EB29-561F-8F83FC2F227B}"/>
              </a:ext>
            </a:extLst>
          </p:cNvPr>
          <p:cNvSpPr>
            <a:spLocks noGrp="1" noRot="1" noMove="1" noResize="1" noEditPoints="1" noAdjustHandles="1" noChangeArrowheads="1" noChangeShapeType="1"/>
          </p:cNvSpPr>
          <p:nvPr/>
        </p:nvSpPr>
        <p:spPr>
          <a:xfrm>
            <a:off x="845127" y="10373163"/>
            <a:ext cx="7093528" cy="5609946"/>
          </a:xfrm>
          <a:prstGeom prst="roundRect">
            <a:avLst>
              <a:gd name="adj" fmla="val 3220"/>
            </a:avLst>
          </a:prstGeom>
          <a:solidFill>
            <a:schemeClr val="bg1"/>
          </a:solidFill>
          <a:ln w="3175"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74" name="Group 73">
            <a:extLst>
              <a:ext uri="{FF2B5EF4-FFF2-40B4-BE49-F238E27FC236}">
                <a16:creationId xmlns:a16="http://schemas.microsoft.com/office/drawing/2014/main" id="{AA476274-B20F-A1AF-4ABF-6548336F5096}"/>
              </a:ext>
            </a:extLst>
          </p:cNvPr>
          <p:cNvGrpSpPr/>
          <p:nvPr/>
        </p:nvGrpSpPr>
        <p:grpSpPr>
          <a:xfrm>
            <a:off x="3439258" y="12574061"/>
            <a:ext cx="1972979" cy="1973481"/>
            <a:chOff x="2360031" y="5804950"/>
            <a:chExt cx="1972979" cy="1973481"/>
          </a:xfrm>
        </p:grpSpPr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68C3B071-144A-37BA-AB11-D002D22A66F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524990" y="5974114"/>
              <a:ext cx="1808020" cy="1804317"/>
            </a:xfrm>
            <a:prstGeom prst="rect">
              <a:avLst/>
            </a:prstGeom>
            <a:solidFill>
              <a:srgbClr val="E0F2F8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EEE23D57-D758-B3E6-E6A5-DE5C1E4022F9}"/>
                </a:ext>
              </a:extLst>
            </p:cNvPr>
            <p:cNvSpPr txBox="1"/>
            <p:nvPr/>
          </p:nvSpPr>
          <p:spPr>
            <a:xfrm>
              <a:off x="2566947" y="6028807"/>
              <a:ext cx="1724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/>
                <a:t>Iceberg</a:t>
              </a:r>
            </a:p>
            <a:p>
              <a:r>
                <a:rPr lang="en-US" sz="600" dirty="0"/>
                <a:t>Something that can stop the project (even in a later point)</a:t>
              </a:r>
            </a:p>
          </p:txBody>
        </p:sp>
        <p:sp>
          <p:nvSpPr>
            <p:cNvPr id="77" name="Oval 76">
              <a:extLst>
                <a:ext uri="{FF2B5EF4-FFF2-40B4-BE49-F238E27FC236}">
                  <a16:creationId xmlns:a16="http://schemas.microsoft.com/office/drawing/2014/main" id="{0CA5669F-223F-4BDF-D726-C2B21FE46FD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360031" y="5804950"/>
              <a:ext cx="329917" cy="338328"/>
            </a:xfrm>
            <a:prstGeom prst="ellipse">
              <a:avLst/>
            </a:prstGeom>
            <a:solidFill>
              <a:srgbClr val="A7CDF4"/>
            </a:solidFill>
            <a:ln w="3175">
              <a:solidFill>
                <a:srgbClr val="88AACD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78" name="Graphic 77" descr="Iceberg with solid fill">
              <a:extLst>
                <a:ext uri="{FF2B5EF4-FFF2-40B4-BE49-F238E27FC236}">
                  <a16:creationId xmlns:a16="http://schemas.microsoft.com/office/drawing/2014/main" id="{4DFBB86A-BE3A-6582-CD68-91088298503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2419103" y="5868228"/>
              <a:ext cx="211772" cy="211772"/>
            </a:xfrm>
            <a:prstGeom prst="rect">
              <a:avLst/>
            </a:prstGeom>
          </p:spPr>
        </p:pic>
      </p:grpSp>
      <p:grpSp>
        <p:nvGrpSpPr>
          <p:cNvPr id="79" name="Group 78">
            <a:extLst>
              <a:ext uri="{FF2B5EF4-FFF2-40B4-BE49-F238E27FC236}">
                <a16:creationId xmlns:a16="http://schemas.microsoft.com/office/drawing/2014/main" id="{220040BF-B1C6-4277-A149-E203441FCAD0}"/>
              </a:ext>
            </a:extLst>
          </p:cNvPr>
          <p:cNvGrpSpPr/>
          <p:nvPr/>
        </p:nvGrpSpPr>
        <p:grpSpPr>
          <a:xfrm>
            <a:off x="962420" y="10470703"/>
            <a:ext cx="2036211" cy="1911300"/>
            <a:chOff x="190089" y="3748771"/>
            <a:chExt cx="2036211" cy="1911300"/>
          </a:xfrm>
        </p:grpSpPr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1561C4D0-8C36-ABF2-CAA3-397EFFCF2B6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59108" y="3855754"/>
              <a:ext cx="1808020" cy="1804317"/>
            </a:xfrm>
            <a:prstGeom prst="rect">
              <a:avLst/>
            </a:prstGeom>
            <a:solidFill>
              <a:srgbClr val="BCD9F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758DE67F-C124-6082-430B-C4496C8EB295}"/>
                </a:ext>
              </a:extLst>
            </p:cNvPr>
            <p:cNvSpPr txBox="1"/>
            <p:nvPr/>
          </p:nvSpPr>
          <p:spPr>
            <a:xfrm>
              <a:off x="502194" y="3910302"/>
              <a:ext cx="1724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/>
                <a:t>Wind</a:t>
              </a:r>
            </a:p>
            <a:p>
              <a:r>
                <a:rPr lang="en-US" sz="600" dirty="0"/>
                <a:t>Things that help the project to propel forward to reach its goals</a:t>
              </a:r>
            </a:p>
          </p:txBody>
        </p:sp>
        <p:sp>
          <p:nvSpPr>
            <p:cNvPr id="82" name="Oval 81">
              <a:extLst>
                <a:ext uri="{FF2B5EF4-FFF2-40B4-BE49-F238E27FC236}">
                  <a16:creationId xmlns:a16="http://schemas.microsoft.com/office/drawing/2014/main" id="{920C50D8-44D5-2F2D-AD55-EF6FCE2905E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90089" y="3748771"/>
              <a:ext cx="329917" cy="338328"/>
            </a:xfrm>
            <a:prstGeom prst="ellipse">
              <a:avLst/>
            </a:prstGeom>
            <a:solidFill>
              <a:srgbClr val="6476D0"/>
            </a:solidFill>
            <a:ln w="3175">
              <a:solidFill>
                <a:srgbClr val="6476D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83" name="Graphic 82" descr="Windy with solid fill">
              <a:extLst>
                <a:ext uri="{FF2B5EF4-FFF2-40B4-BE49-F238E27FC236}">
                  <a16:creationId xmlns:a16="http://schemas.microsoft.com/office/drawing/2014/main" id="{459A2F98-7AE1-BA98-D1D9-16EE8345E0A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229297" y="3792185"/>
              <a:ext cx="251501" cy="251501"/>
            </a:xfrm>
            <a:prstGeom prst="rect">
              <a:avLst/>
            </a:prstGeom>
          </p:spPr>
        </p:pic>
      </p:grpSp>
      <p:grpSp>
        <p:nvGrpSpPr>
          <p:cNvPr id="84" name="Group 83">
            <a:extLst>
              <a:ext uri="{FF2B5EF4-FFF2-40B4-BE49-F238E27FC236}">
                <a16:creationId xmlns:a16="http://schemas.microsoft.com/office/drawing/2014/main" id="{292CD7B4-6BC1-B258-0489-072923C8B26F}"/>
              </a:ext>
            </a:extLst>
          </p:cNvPr>
          <p:cNvGrpSpPr/>
          <p:nvPr/>
        </p:nvGrpSpPr>
        <p:grpSpPr>
          <a:xfrm>
            <a:off x="5781539" y="10478478"/>
            <a:ext cx="2009037" cy="1935294"/>
            <a:chOff x="4489855" y="3748771"/>
            <a:chExt cx="2009037" cy="1935294"/>
          </a:xfrm>
        </p:grpSpPr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41942011-E8E3-7089-AE54-D04AAA1E111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690872" y="3879748"/>
              <a:ext cx="1808020" cy="1804317"/>
            </a:xfrm>
            <a:prstGeom prst="rect">
              <a:avLst/>
            </a:prstGeom>
            <a:solidFill>
              <a:srgbClr val="DBEEC9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82A82195-3DF1-E793-197C-2AFD228FE214}"/>
                </a:ext>
              </a:extLst>
            </p:cNvPr>
            <p:cNvSpPr txBox="1"/>
            <p:nvPr/>
          </p:nvSpPr>
          <p:spPr>
            <a:xfrm>
              <a:off x="4774786" y="3922547"/>
              <a:ext cx="1724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/>
                <a:t>Anchors</a:t>
              </a:r>
            </a:p>
            <a:p>
              <a:r>
                <a:rPr lang="en-US" sz="600" dirty="0"/>
                <a:t>Everything that slows the project down or holds it back</a:t>
              </a:r>
            </a:p>
          </p:txBody>
        </p:sp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5252033F-6642-4C00-44E9-A4ACFE03701C}"/>
                </a:ext>
              </a:extLst>
            </p:cNvPr>
            <p:cNvGrpSpPr/>
            <p:nvPr/>
          </p:nvGrpSpPr>
          <p:grpSpPr>
            <a:xfrm>
              <a:off x="4489855" y="3748771"/>
              <a:ext cx="329917" cy="338328"/>
              <a:chOff x="4489855" y="3748771"/>
              <a:chExt cx="329917" cy="338328"/>
            </a:xfrm>
          </p:grpSpPr>
          <p:sp>
            <p:nvSpPr>
              <p:cNvPr id="88" name="Oval 87">
                <a:extLst>
                  <a:ext uri="{FF2B5EF4-FFF2-40B4-BE49-F238E27FC236}">
                    <a16:creationId xmlns:a16="http://schemas.microsoft.com/office/drawing/2014/main" id="{4B94F4A0-ACBE-150F-DDDD-BA307E50D07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489855" y="3748771"/>
                <a:ext cx="329917" cy="338328"/>
              </a:xfrm>
              <a:prstGeom prst="ellipse">
                <a:avLst/>
              </a:prstGeom>
              <a:solidFill>
                <a:srgbClr val="59A09C"/>
              </a:solidFill>
              <a:ln w="3175">
                <a:solidFill>
                  <a:srgbClr val="62A8A4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pic>
            <p:nvPicPr>
              <p:cNvPr id="89" name="Graphic 88" descr="Anchor with solid fill">
                <a:extLst>
                  <a:ext uri="{FF2B5EF4-FFF2-40B4-BE49-F238E27FC236}">
                    <a16:creationId xmlns:a16="http://schemas.microsoft.com/office/drawing/2014/main" id="{AB35AD52-2080-ECF9-C64D-B565B9C822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96DAC541-7B7A-43D3-8B79-37D633B846F1}">
                    <asvg:svgBlip xmlns:asvg="http://schemas.microsoft.com/office/drawing/2016/SVG/main" r:embed="rId7"/>
                  </a:ext>
                </a:extLst>
              </a:blip>
              <a:stretch>
                <a:fillRect/>
              </a:stretch>
            </p:blipFill>
            <p:spPr>
              <a:xfrm>
                <a:off x="4563448" y="3826570"/>
                <a:ext cx="182730" cy="182730"/>
              </a:xfrm>
              <a:prstGeom prst="rect">
                <a:avLst/>
              </a:prstGeom>
            </p:spPr>
          </p:pic>
        </p:grpSp>
      </p:grpSp>
      <p:sp>
        <p:nvSpPr>
          <p:cNvPr id="90" name="Folded Corner 89">
            <a:extLst>
              <a:ext uri="{FF2B5EF4-FFF2-40B4-BE49-F238E27FC236}">
                <a16:creationId xmlns:a16="http://schemas.microsoft.com/office/drawing/2014/main" id="{ADE4A54B-2A58-6BFF-5458-340B209D6867}"/>
              </a:ext>
            </a:extLst>
          </p:cNvPr>
          <p:cNvSpPr>
            <a:spLocks noChangeAspect="1"/>
          </p:cNvSpPr>
          <p:nvPr/>
        </p:nvSpPr>
        <p:spPr>
          <a:xfrm>
            <a:off x="1295054" y="11156244"/>
            <a:ext cx="597855" cy="616538"/>
          </a:xfrm>
          <a:prstGeom prst="foldedCorner">
            <a:avLst/>
          </a:prstGeom>
          <a:solidFill>
            <a:srgbClr val="7F96FE"/>
          </a:solidFill>
          <a:ln w="3175">
            <a:solidFill>
              <a:srgbClr val="5A6ABB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sp>
        <p:nvSpPr>
          <p:cNvPr id="91" name="Folded Corner 90">
            <a:extLst>
              <a:ext uri="{FF2B5EF4-FFF2-40B4-BE49-F238E27FC236}">
                <a16:creationId xmlns:a16="http://schemas.microsoft.com/office/drawing/2014/main" id="{9A63DA99-F0F3-DFC5-6D04-8DE615C4FCC7}"/>
              </a:ext>
            </a:extLst>
          </p:cNvPr>
          <p:cNvSpPr>
            <a:spLocks noChangeAspect="1"/>
          </p:cNvSpPr>
          <p:nvPr/>
        </p:nvSpPr>
        <p:spPr>
          <a:xfrm>
            <a:off x="2149443" y="11111709"/>
            <a:ext cx="597855" cy="616538"/>
          </a:xfrm>
          <a:prstGeom prst="foldedCorner">
            <a:avLst/>
          </a:prstGeom>
          <a:solidFill>
            <a:srgbClr val="7F96FE"/>
          </a:solidFill>
          <a:ln w="3175">
            <a:solidFill>
              <a:srgbClr val="5A6ABB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sp>
        <p:nvSpPr>
          <p:cNvPr id="92" name="Folded Corner 91">
            <a:extLst>
              <a:ext uri="{FF2B5EF4-FFF2-40B4-BE49-F238E27FC236}">
                <a16:creationId xmlns:a16="http://schemas.microsoft.com/office/drawing/2014/main" id="{654B15C0-B05A-111C-0BA4-E3F910B11A5B}"/>
              </a:ext>
            </a:extLst>
          </p:cNvPr>
          <p:cNvSpPr>
            <a:spLocks noChangeAspect="1"/>
          </p:cNvSpPr>
          <p:nvPr/>
        </p:nvSpPr>
        <p:spPr>
          <a:xfrm>
            <a:off x="1917517" y="11800230"/>
            <a:ext cx="597855" cy="616538"/>
          </a:xfrm>
          <a:prstGeom prst="foldedCorner">
            <a:avLst/>
          </a:prstGeom>
          <a:solidFill>
            <a:srgbClr val="7F96FE"/>
          </a:solidFill>
          <a:ln w="3175">
            <a:solidFill>
              <a:srgbClr val="5A6ABB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sp>
        <p:nvSpPr>
          <p:cNvPr id="93" name="Folded Corner 92">
            <a:extLst>
              <a:ext uri="{FF2B5EF4-FFF2-40B4-BE49-F238E27FC236}">
                <a16:creationId xmlns:a16="http://schemas.microsoft.com/office/drawing/2014/main" id="{AB38BA26-C29D-4D14-92D2-411FF03DE5FA}"/>
              </a:ext>
            </a:extLst>
          </p:cNvPr>
          <p:cNvSpPr>
            <a:spLocks noChangeAspect="1"/>
          </p:cNvSpPr>
          <p:nvPr/>
        </p:nvSpPr>
        <p:spPr>
          <a:xfrm>
            <a:off x="6189536" y="11177242"/>
            <a:ext cx="597855" cy="616538"/>
          </a:xfrm>
          <a:prstGeom prst="foldedCorner">
            <a:avLst/>
          </a:prstGeom>
          <a:solidFill>
            <a:srgbClr val="7CCEC8"/>
          </a:solidFill>
          <a:ln w="3175">
            <a:solidFill>
              <a:srgbClr val="59A09C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sp>
        <p:nvSpPr>
          <p:cNvPr id="94" name="Folded Corner 93">
            <a:extLst>
              <a:ext uri="{FF2B5EF4-FFF2-40B4-BE49-F238E27FC236}">
                <a16:creationId xmlns:a16="http://schemas.microsoft.com/office/drawing/2014/main" id="{EBA649BC-CBA6-7598-6CE8-1770F564C4E3}"/>
              </a:ext>
            </a:extLst>
          </p:cNvPr>
          <p:cNvSpPr>
            <a:spLocks noChangeAspect="1"/>
          </p:cNvSpPr>
          <p:nvPr/>
        </p:nvSpPr>
        <p:spPr>
          <a:xfrm>
            <a:off x="7043925" y="11132707"/>
            <a:ext cx="597855" cy="616538"/>
          </a:xfrm>
          <a:prstGeom prst="foldedCorner">
            <a:avLst/>
          </a:prstGeom>
          <a:solidFill>
            <a:srgbClr val="7CCEC8"/>
          </a:solidFill>
          <a:ln w="3175">
            <a:solidFill>
              <a:srgbClr val="59A09C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sp>
        <p:nvSpPr>
          <p:cNvPr id="95" name="Folded Corner 94">
            <a:extLst>
              <a:ext uri="{FF2B5EF4-FFF2-40B4-BE49-F238E27FC236}">
                <a16:creationId xmlns:a16="http://schemas.microsoft.com/office/drawing/2014/main" id="{92A9B1D3-D134-7588-6B3E-D1AB8FA9E2EE}"/>
              </a:ext>
            </a:extLst>
          </p:cNvPr>
          <p:cNvSpPr>
            <a:spLocks noChangeAspect="1"/>
          </p:cNvSpPr>
          <p:nvPr/>
        </p:nvSpPr>
        <p:spPr>
          <a:xfrm>
            <a:off x="6744997" y="11965136"/>
            <a:ext cx="597855" cy="616538"/>
          </a:xfrm>
          <a:prstGeom prst="foldedCorner">
            <a:avLst/>
          </a:prstGeom>
          <a:solidFill>
            <a:srgbClr val="7CCEC8"/>
          </a:solidFill>
          <a:ln w="3175">
            <a:solidFill>
              <a:srgbClr val="59A09C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sp>
        <p:nvSpPr>
          <p:cNvPr id="96" name="Folded Corner 95">
            <a:extLst>
              <a:ext uri="{FF2B5EF4-FFF2-40B4-BE49-F238E27FC236}">
                <a16:creationId xmlns:a16="http://schemas.microsoft.com/office/drawing/2014/main" id="{46D71CDF-B9A4-897A-03EC-6AA289B7A693}"/>
              </a:ext>
            </a:extLst>
          </p:cNvPr>
          <p:cNvSpPr>
            <a:spLocks noChangeAspect="1"/>
          </p:cNvSpPr>
          <p:nvPr/>
        </p:nvSpPr>
        <p:spPr>
          <a:xfrm>
            <a:off x="3811197" y="13311006"/>
            <a:ext cx="597855" cy="616538"/>
          </a:xfrm>
          <a:prstGeom prst="foldedCorner">
            <a:avLst/>
          </a:prstGeom>
          <a:solidFill>
            <a:srgbClr val="A7CDF4"/>
          </a:solidFill>
          <a:ln w="3175">
            <a:solidFill>
              <a:srgbClr val="8FAFD2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sp>
        <p:nvSpPr>
          <p:cNvPr id="97" name="Folded Corner 96">
            <a:extLst>
              <a:ext uri="{FF2B5EF4-FFF2-40B4-BE49-F238E27FC236}">
                <a16:creationId xmlns:a16="http://schemas.microsoft.com/office/drawing/2014/main" id="{F17F5BF9-EF2D-EF4C-28FF-8DAA3A07BDCE}"/>
              </a:ext>
            </a:extLst>
          </p:cNvPr>
          <p:cNvSpPr>
            <a:spLocks noChangeAspect="1"/>
          </p:cNvSpPr>
          <p:nvPr/>
        </p:nvSpPr>
        <p:spPr>
          <a:xfrm>
            <a:off x="4665586" y="13266471"/>
            <a:ext cx="597855" cy="616538"/>
          </a:xfrm>
          <a:prstGeom prst="foldedCorner">
            <a:avLst/>
          </a:prstGeom>
          <a:solidFill>
            <a:srgbClr val="A7CDF4"/>
          </a:solidFill>
          <a:ln w="3175">
            <a:solidFill>
              <a:srgbClr val="8FAFD2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sp>
        <p:nvSpPr>
          <p:cNvPr id="98" name="Folded Corner 97">
            <a:extLst>
              <a:ext uri="{FF2B5EF4-FFF2-40B4-BE49-F238E27FC236}">
                <a16:creationId xmlns:a16="http://schemas.microsoft.com/office/drawing/2014/main" id="{C0826231-005E-E342-35CF-1714413F07CD}"/>
              </a:ext>
            </a:extLst>
          </p:cNvPr>
          <p:cNvSpPr>
            <a:spLocks noChangeAspect="1"/>
          </p:cNvSpPr>
          <p:nvPr/>
        </p:nvSpPr>
        <p:spPr>
          <a:xfrm>
            <a:off x="4305727" y="14004415"/>
            <a:ext cx="597855" cy="616538"/>
          </a:xfrm>
          <a:prstGeom prst="foldedCorner">
            <a:avLst/>
          </a:prstGeom>
          <a:solidFill>
            <a:srgbClr val="A7CDF4"/>
          </a:solidFill>
          <a:ln w="3175">
            <a:solidFill>
              <a:srgbClr val="8FAFD2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700" dirty="0"/>
          </a:p>
        </p:txBody>
      </p:sp>
      <p:grpSp>
        <p:nvGrpSpPr>
          <p:cNvPr id="99" name="Group 98">
            <a:extLst>
              <a:ext uri="{FF2B5EF4-FFF2-40B4-BE49-F238E27FC236}">
                <a16:creationId xmlns:a16="http://schemas.microsoft.com/office/drawing/2014/main" id="{16F3E14C-BA41-400E-5965-C47555417162}"/>
              </a:ext>
            </a:extLst>
          </p:cNvPr>
          <p:cNvGrpSpPr/>
          <p:nvPr/>
        </p:nvGrpSpPr>
        <p:grpSpPr>
          <a:xfrm>
            <a:off x="1526964" y="14890767"/>
            <a:ext cx="5920849" cy="784985"/>
            <a:chOff x="1141833" y="8066246"/>
            <a:chExt cx="4677409" cy="784985"/>
          </a:xfrm>
        </p:grpSpPr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id="{94E9269F-6FB4-5FCC-5A35-736478AE984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141833" y="8066246"/>
              <a:ext cx="4677409" cy="784985"/>
            </a:xfrm>
            <a:prstGeom prst="rect">
              <a:avLst/>
            </a:prstGeom>
            <a:solidFill>
              <a:srgbClr val="FEDAA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A905F69E-2524-EC1B-4FF9-43CB93418281}"/>
                </a:ext>
              </a:extLst>
            </p:cNvPr>
            <p:cNvSpPr txBox="1"/>
            <p:nvPr/>
          </p:nvSpPr>
          <p:spPr>
            <a:xfrm>
              <a:off x="1263118" y="8139663"/>
              <a:ext cx="439106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/>
                <a:t>Action Plan</a:t>
              </a:r>
            </a:p>
            <a:p>
              <a:r>
                <a:rPr lang="en-US" sz="600" dirty="0"/>
                <a:t>Create an action plan using SMART (Specific, Measurable, Achievable, Relevant, and Time-Bound) format objectives</a:t>
              </a:r>
            </a:p>
            <a:p>
              <a:r>
                <a:rPr lang="en-US" sz="600" dirty="0"/>
                <a:t>1. </a:t>
              </a:r>
            </a:p>
            <a:p>
              <a:r>
                <a:rPr lang="en-US" sz="600" dirty="0"/>
                <a:t>2. </a:t>
              </a:r>
            </a:p>
            <a:p>
              <a:r>
                <a:rPr lang="en-US" sz="600" dirty="0"/>
                <a:t>3. </a:t>
              </a:r>
            </a:p>
            <a:p>
              <a:endParaRPr lang="en-US" sz="600" dirty="0"/>
            </a:p>
          </p:txBody>
        </p:sp>
      </p:grp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06286DBA-9838-8E6C-01C8-AC7CEC1FE3DA}"/>
              </a:ext>
            </a:extLst>
          </p:cNvPr>
          <p:cNvGrpSpPr/>
          <p:nvPr/>
        </p:nvGrpSpPr>
        <p:grpSpPr>
          <a:xfrm>
            <a:off x="6144561" y="12990288"/>
            <a:ext cx="841749" cy="868054"/>
            <a:chOff x="4678566" y="5974114"/>
            <a:chExt cx="841749" cy="868054"/>
          </a:xfrm>
        </p:grpSpPr>
        <p:sp>
          <p:nvSpPr>
            <p:cNvPr id="103" name="Folded Corner 102">
              <a:extLst>
                <a:ext uri="{FF2B5EF4-FFF2-40B4-BE49-F238E27FC236}">
                  <a16:creationId xmlns:a16="http://schemas.microsoft.com/office/drawing/2014/main" id="{DD3BA7C3-DE41-0158-D040-1AC48F219DB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678566" y="5974114"/>
              <a:ext cx="841749" cy="868054"/>
            </a:xfrm>
            <a:prstGeom prst="foldedCorner">
              <a:avLst/>
            </a:prstGeom>
            <a:solidFill>
              <a:srgbClr val="FE9D4B"/>
            </a:solidFill>
            <a:ln w="3175">
              <a:solidFill>
                <a:srgbClr val="E58C45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dirty="0">
                <a:solidFill>
                  <a:schemeClr val="tx1"/>
                </a:solidFill>
              </a:endParaRP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58A1E788-4226-1F78-7CDF-DF94B3432DD8}"/>
                </a:ext>
              </a:extLst>
            </p:cNvPr>
            <p:cNvSpPr txBox="1"/>
            <p:nvPr/>
          </p:nvSpPr>
          <p:spPr>
            <a:xfrm>
              <a:off x="4703174" y="5997950"/>
              <a:ext cx="817141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/>
                <a:t>Questions</a:t>
              </a:r>
            </a:p>
            <a:p>
              <a:r>
                <a:rPr lang="en-US" sz="700" dirty="0"/>
                <a:t>1. </a:t>
              </a:r>
            </a:p>
            <a:p>
              <a:r>
                <a:rPr lang="en-US" sz="700" dirty="0"/>
                <a:t>2. </a:t>
              </a:r>
            </a:p>
            <a:p>
              <a:r>
                <a:rPr lang="en-US" sz="700" dirty="0"/>
                <a:t>3. </a:t>
              </a:r>
            </a:p>
            <a:p>
              <a:endParaRPr lang="en-US" sz="700" dirty="0"/>
            </a:p>
          </p:txBody>
        </p:sp>
      </p:grpSp>
      <p:sp>
        <p:nvSpPr>
          <p:cNvPr id="105" name="Rectangle 104">
            <a:extLst>
              <a:ext uri="{FF2B5EF4-FFF2-40B4-BE49-F238E27FC236}">
                <a16:creationId xmlns:a16="http://schemas.microsoft.com/office/drawing/2014/main" id="{59B58162-C2D3-C69B-AC6C-4CF8F479B9EF}"/>
              </a:ext>
            </a:extLst>
          </p:cNvPr>
          <p:cNvSpPr>
            <a:spLocks/>
          </p:cNvSpPr>
          <p:nvPr/>
        </p:nvSpPr>
        <p:spPr>
          <a:xfrm>
            <a:off x="3176536" y="10755211"/>
            <a:ext cx="2547229" cy="1642449"/>
          </a:xfrm>
          <a:custGeom>
            <a:avLst/>
            <a:gdLst>
              <a:gd name="connsiteX0" fmla="*/ 0 w 2547229"/>
              <a:gd name="connsiteY0" fmla="*/ 0 h 1642449"/>
              <a:gd name="connsiteX1" fmla="*/ 687752 w 2547229"/>
              <a:gd name="connsiteY1" fmla="*/ 0 h 1642449"/>
              <a:gd name="connsiteX2" fmla="*/ 1350031 w 2547229"/>
              <a:gd name="connsiteY2" fmla="*/ 0 h 1642449"/>
              <a:gd name="connsiteX3" fmla="*/ 2547229 w 2547229"/>
              <a:gd name="connsiteY3" fmla="*/ 0 h 1642449"/>
              <a:gd name="connsiteX4" fmla="*/ 2547229 w 2547229"/>
              <a:gd name="connsiteY4" fmla="*/ 498210 h 1642449"/>
              <a:gd name="connsiteX5" fmla="*/ 2547229 w 2547229"/>
              <a:gd name="connsiteY5" fmla="*/ 1078542 h 1642449"/>
              <a:gd name="connsiteX6" fmla="*/ 2547229 w 2547229"/>
              <a:gd name="connsiteY6" fmla="*/ 1642449 h 1642449"/>
              <a:gd name="connsiteX7" fmla="*/ 1961366 w 2547229"/>
              <a:gd name="connsiteY7" fmla="*/ 1642449 h 1642449"/>
              <a:gd name="connsiteX8" fmla="*/ 1350031 w 2547229"/>
              <a:gd name="connsiteY8" fmla="*/ 1642449 h 1642449"/>
              <a:gd name="connsiteX9" fmla="*/ 789641 w 2547229"/>
              <a:gd name="connsiteY9" fmla="*/ 1642449 h 1642449"/>
              <a:gd name="connsiteX10" fmla="*/ 0 w 2547229"/>
              <a:gd name="connsiteY10" fmla="*/ 1642449 h 1642449"/>
              <a:gd name="connsiteX11" fmla="*/ 0 w 2547229"/>
              <a:gd name="connsiteY11" fmla="*/ 1078542 h 1642449"/>
              <a:gd name="connsiteX12" fmla="*/ 0 w 2547229"/>
              <a:gd name="connsiteY12" fmla="*/ 580332 h 1642449"/>
              <a:gd name="connsiteX13" fmla="*/ 0 w 2547229"/>
              <a:gd name="connsiteY13" fmla="*/ 0 h 164244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2547229" h="1642449" fill="none" extrusionOk="0">
                <a:moveTo>
                  <a:pt x="0" y="0"/>
                </a:moveTo>
                <a:cubicBezTo>
                  <a:pt x="325424" y="-23027"/>
                  <a:pt x="365124" y="28164"/>
                  <a:pt x="687752" y="0"/>
                </a:cubicBezTo>
                <a:cubicBezTo>
                  <a:pt x="1010380" y="-28164"/>
                  <a:pt x="1135031" y="31141"/>
                  <a:pt x="1350031" y="0"/>
                </a:cubicBezTo>
                <a:cubicBezTo>
                  <a:pt x="1565031" y="-31141"/>
                  <a:pt x="2175744" y="-32168"/>
                  <a:pt x="2547229" y="0"/>
                </a:cubicBezTo>
                <a:cubicBezTo>
                  <a:pt x="2551391" y="191893"/>
                  <a:pt x="2565830" y="262210"/>
                  <a:pt x="2547229" y="498210"/>
                </a:cubicBezTo>
                <a:cubicBezTo>
                  <a:pt x="2528629" y="734210"/>
                  <a:pt x="2573659" y="866972"/>
                  <a:pt x="2547229" y="1078542"/>
                </a:cubicBezTo>
                <a:cubicBezTo>
                  <a:pt x="2520799" y="1290112"/>
                  <a:pt x="2525193" y="1450412"/>
                  <a:pt x="2547229" y="1642449"/>
                </a:cubicBezTo>
                <a:cubicBezTo>
                  <a:pt x="2355642" y="1661067"/>
                  <a:pt x="2250314" y="1621136"/>
                  <a:pt x="1961366" y="1642449"/>
                </a:cubicBezTo>
                <a:cubicBezTo>
                  <a:pt x="1672418" y="1663762"/>
                  <a:pt x="1600128" y="1629959"/>
                  <a:pt x="1350031" y="1642449"/>
                </a:cubicBezTo>
                <a:cubicBezTo>
                  <a:pt x="1099934" y="1654939"/>
                  <a:pt x="1054394" y="1638243"/>
                  <a:pt x="789641" y="1642449"/>
                </a:cubicBezTo>
                <a:cubicBezTo>
                  <a:pt x="524888" y="1646656"/>
                  <a:pt x="299126" y="1627472"/>
                  <a:pt x="0" y="1642449"/>
                </a:cubicBezTo>
                <a:cubicBezTo>
                  <a:pt x="21204" y="1445694"/>
                  <a:pt x="15220" y="1263651"/>
                  <a:pt x="0" y="1078542"/>
                </a:cubicBezTo>
                <a:cubicBezTo>
                  <a:pt x="-15220" y="893433"/>
                  <a:pt x="-5299" y="796020"/>
                  <a:pt x="0" y="580332"/>
                </a:cubicBezTo>
                <a:cubicBezTo>
                  <a:pt x="5299" y="364644"/>
                  <a:pt x="-108" y="122678"/>
                  <a:pt x="0" y="0"/>
                </a:cubicBezTo>
                <a:close/>
              </a:path>
              <a:path w="2547229" h="1642449" stroke="0" extrusionOk="0">
                <a:moveTo>
                  <a:pt x="0" y="0"/>
                </a:moveTo>
                <a:cubicBezTo>
                  <a:pt x="190508" y="19255"/>
                  <a:pt x="316844" y="16270"/>
                  <a:pt x="611335" y="0"/>
                </a:cubicBezTo>
                <a:cubicBezTo>
                  <a:pt x="905827" y="-16270"/>
                  <a:pt x="956471" y="22607"/>
                  <a:pt x="1171725" y="0"/>
                </a:cubicBezTo>
                <a:cubicBezTo>
                  <a:pt x="1386979" y="-22607"/>
                  <a:pt x="1700282" y="-24164"/>
                  <a:pt x="1859477" y="0"/>
                </a:cubicBezTo>
                <a:cubicBezTo>
                  <a:pt x="2018672" y="24164"/>
                  <a:pt x="2265871" y="-4731"/>
                  <a:pt x="2547229" y="0"/>
                </a:cubicBezTo>
                <a:cubicBezTo>
                  <a:pt x="2553623" y="250865"/>
                  <a:pt x="2567924" y="295384"/>
                  <a:pt x="2547229" y="531059"/>
                </a:cubicBezTo>
                <a:cubicBezTo>
                  <a:pt x="2526534" y="766734"/>
                  <a:pt x="2571855" y="865137"/>
                  <a:pt x="2547229" y="1045693"/>
                </a:cubicBezTo>
                <a:cubicBezTo>
                  <a:pt x="2522603" y="1226249"/>
                  <a:pt x="2553795" y="1387078"/>
                  <a:pt x="2547229" y="1642449"/>
                </a:cubicBezTo>
                <a:cubicBezTo>
                  <a:pt x="2370544" y="1644645"/>
                  <a:pt x="2115330" y="1665450"/>
                  <a:pt x="1910422" y="1642449"/>
                </a:cubicBezTo>
                <a:cubicBezTo>
                  <a:pt x="1705514" y="1619448"/>
                  <a:pt x="1470309" y="1653754"/>
                  <a:pt x="1350031" y="1642449"/>
                </a:cubicBezTo>
                <a:cubicBezTo>
                  <a:pt x="1229753" y="1631144"/>
                  <a:pt x="979307" y="1671219"/>
                  <a:pt x="713224" y="1642449"/>
                </a:cubicBezTo>
                <a:cubicBezTo>
                  <a:pt x="447141" y="1613679"/>
                  <a:pt x="267897" y="1627863"/>
                  <a:pt x="0" y="1642449"/>
                </a:cubicBezTo>
                <a:cubicBezTo>
                  <a:pt x="2076" y="1430950"/>
                  <a:pt x="-20250" y="1225905"/>
                  <a:pt x="0" y="1111390"/>
                </a:cubicBezTo>
                <a:cubicBezTo>
                  <a:pt x="20250" y="996875"/>
                  <a:pt x="3077" y="844049"/>
                  <a:pt x="0" y="580332"/>
                </a:cubicBezTo>
                <a:cubicBezTo>
                  <a:pt x="-3077" y="316615"/>
                  <a:pt x="-24917" y="138909"/>
                  <a:pt x="0" y="0"/>
                </a:cubicBezTo>
                <a:close/>
              </a:path>
            </a:pathLst>
          </a:custGeom>
          <a:solidFill>
            <a:schemeClr val="bg1"/>
          </a:solidFill>
          <a:ln w="3175">
            <a:solidFill>
              <a:schemeClr val="tx1">
                <a:lumMod val="75000"/>
                <a:lumOff val="25000"/>
              </a:schemeClr>
            </a:solidFill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380FBCC8-DC75-3A68-0356-D81C8973E95E}"/>
              </a:ext>
            </a:extLst>
          </p:cNvPr>
          <p:cNvSpPr txBox="1"/>
          <p:nvPr/>
        </p:nvSpPr>
        <p:spPr>
          <a:xfrm>
            <a:off x="3659226" y="11158566"/>
            <a:ext cx="14977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Bradley Hand ITC" panose="03070402050302030203" pitchFamily="66" charset="77"/>
              </a:rPr>
              <a:t>Participant’s Sailboat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9DB96980-2F02-02F3-DAC7-B6358AE2EE40}"/>
              </a:ext>
            </a:extLst>
          </p:cNvPr>
          <p:cNvSpPr txBox="1"/>
          <p:nvPr/>
        </p:nvSpPr>
        <p:spPr>
          <a:xfrm>
            <a:off x="3621260" y="10084446"/>
            <a:ext cx="1343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articipant Nam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4F16AAA-FE15-3AE1-2D75-DE336826A8E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32037" y="1662012"/>
            <a:ext cx="2506890" cy="149014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0578EA1-5F5E-E4C0-00B1-4AE1E382369B}"/>
              </a:ext>
            </a:extLst>
          </p:cNvPr>
          <p:cNvSpPr txBox="1"/>
          <p:nvPr/>
        </p:nvSpPr>
        <p:spPr>
          <a:xfrm>
            <a:off x="6877274" y="15995848"/>
            <a:ext cx="19287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“Author owned image.”</a:t>
            </a:r>
            <a:r>
              <a:rPr lang="en-US" sz="1400" i="1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US" sz="1400" i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1878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</TotalTime>
  <Words>161</Words>
  <Application>Microsoft Macintosh PowerPoint</Application>
  <PresentationFormat>Custom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Bradley Hand ITC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rz Fresno, Dominique</dc:creator>
  <cp:lastModifiedBy>Krisztina Fischer</cp:lastModifiedBy>
  <cp:revision>5</cp:revision>
  <dcterms:created xsi:type="dcterms:W3CDTF">2024-08-24T23:21:27Z</dcterms:created>
  <dcterms:modified xsi:type="dcterms:W3CDTF">2025-01-31T15:44:06Z</dcterms:modified>
</cp:coreProperties>
</file>